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66" r:id="rId3"/>
    <p:sldId id="267" r:id="rId4"/>
    <p:sldId id="259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4660"/>
  </p:normalViewPr>
  <p:slideViewPr>
    <p:cSldViewPr snapToGrid="0">
      <p:cViewPr varScale="1">
        <p:scale>
          <a:sx n="107" d="100"/>
          <a:sy n="107" d="100"/>
        </p:scale>
        <p:origin x="63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81BB65-C8D3-0314-7AAF-303E41CD946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D32BB4B-C74A-C676-9583-41422337E37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E098C6-973E-450E-CEF0-19C3FC8EE9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6E43B-553D-4B9B-9676-876B5770857C}" type="datetimeFigureOut">
              <a:rPr lang="en-CA" smtClean="0"/>
              <a:t>2026-02-13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89F998-450F-5C48-03FC-669F9ED28D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DC5305-722D-C2C2-65B8-1D10CDBE53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113E3-FE1E-4FA3-A873-D5A7B8769F2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238150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CB001A-0A73-912F-830D-33E3875003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9ECD6A4-0339-E68D-DE7F-5353C2D2FF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4DD96B-86E6-C1C9-A985-2FC8784882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6E43B-553D-4B9B-9676-876B5770857C}" type="datetimeFigureOut">
              <a:rPr lang="en-CA" smtClean="0"/>
              <a:t>2026-02-13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A2D3F9-6C30-BB3F-138C-F81C33C0EF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EEE133-745C-3038-3C72-BA36F80F51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113E3-FE1E-4FA3-A873-D5A7B8769F2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177850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5A9E33A-0874-C098-7ED9-12CDEE5ADC1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9697302-D7C2-55E0-492E-6E79AC0706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E692A3-E4E2-DC5B-7D6D-48A623E87F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6E43B-553D-4B9B-9676-876B5770857C}" type="datetimeFigureOut">
              <a:rPr lang="en-CA" smtClean="0"/>
              <a:t>2026-02-13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3D2EF9-9190-DBF1-2F14-58EB30FC9A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D346C1-D13E-6D6E-328D-F6A612F125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113E3-FE1E-4FA3-A873-D5A7B8769F2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44404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17C437-E1DD-CF7A-0240-936E9FC47D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C8565CD-89BF-A7D9-3F23-FBA02A34160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A5BD18-5F51-999B-3E9A-906410CC57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6E43B-553D-4B9B-9676-876B5770857C}" type="datetimeFigureOut">
              <a:rPr lang="en-CA" smtClean="0"/>
              <a:t>2026-02-13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A33F54-4F80-D113-9AD7-280421B6C3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E3575A-F880-BE19-D211-0FA5149974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113E3-FE1E-4FA3-A873-D5A7B8769F2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208690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C36ACA-ED57-90D3-B043-FB3B8AA930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B05FF4-6EC1-A3EA-2F07-3BFCF87641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BCF7BD-3AF5-C856-6B36-1265257F54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6E43B-553D-4B9B-9676-876B5770857C}" type="datetimeFigureOut">
              <a:rPr lang="en-CA" smtClean="0"/>
              <a:t>2026-02-13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A79962-1284-2AD2-1869-EBB99E7CEB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140CDE-822C-C75D-A42B-247C2A6E19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113E3-FE1E-4FA3-A873-D5A7B8769F2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656097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ECB071-60D0-F06D-533E-98E13FE54D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FF5F35-F9DD-87DE-443C-5C30BF71E9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477A678-8FCA-62B9-32A9-B48450B79B0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227C632-F6E5-19D1-3460-1EF5A1EF3D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6E43B-553D-4B9B-9676-876B5770857C}" type="datetimeFigureOut">
              <a:rPr lang="en-CA" smtClean="0"/>
              <a:t>2026-02-13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A56107-0395-5DF5-9D9A-B346950646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1D5AB5-3F0F-D793-1BB9-C575C57569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113E3-FE1E-4FA3-A873-D5A7B8769F2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65126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31B9A8-98B6-284B-8278-420EC04180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0B29263-E3EA-F94C-008C-3FFC01AED5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F699E6A-4B8A-5C1B-A197-602C7B6183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19FF854-20B8-0264-88E0-F38777B6BAD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9D0A5D1-7405-66EF-9CA1-5D8E3160868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58F9285-F5C8-D890-062B-327B3E18AE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6E43B-553D-4B9B-9676-876B5770857C}" type="datetimeFigureOut">
              <a:rPr lang="en-CA" smtClean="0"/>
              <a:t>2026-02-13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F662550-7D84-CB72-216E-E784D9250A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3BFA7F6-D634-685B-050C-18A32B5259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113E3-FE1E-4FA3-A873-D5A7B8769F2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072948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585DC6-F18F-C7F9-8730-3DF038ACBE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98F416D-E372-D783-4F35-ECA5D5D500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6E43B-553D-4B9B-9676-876B5770857C}" type="datetimeFigureOut">
              <a:rPr lang="en-CA" smtClean="0"/>
              <a:t>2026-02-13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3423F8C-DCC7-8E77-B9E2-13351A4B7A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DB947E8-760E-1A9E-F899-FB038877D0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113E3-FE1E-4FA3-A873-D5A7B8769F2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714558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2FCC9F3-0460-E28C-C8EE-2208133EFA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6E43B-553D-4B9B-9676-876B5770857C}" type="datetimeFigureOut">
              <a:rPr lang="en-CA" smtClean="0"/>
              <a:t>2026-02-13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2026434-4538-D687-1C94-02678C3E6A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4ED9BE8-E391-4D11-E239-BE0D0D0B07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113E3-FE1E-4FA3-A873-D5A7B8769F2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816888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76638C-F6BD-7312-455C-74D8FD7E02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7620CA-1AC9-E114-6B30-B716B770DF8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87295AE-138A-7E8C-F0BD-B25D8BD3F0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C1ED9D-FCBF-A67C-876E-1D21F58BFD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6E43B-553D-4B9B-9676-876B5770857C}" type="datetimeFigureOut">
              <a:rPr lang="en-CA" smtClean="0"/>
              <a:t>2026-02-13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9B32433-963B-E2C8-ED81-A27BB6AB2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F4CC9B-BE5B-2F9C-3333-6A5DBA7B66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113E3-FE1E-4FA3-A873-D5A7B8769F2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426574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6886F9-8E0C-FDC0-8B6E-0624C02E6C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768E9C8-3022-1958-8731-97030200B1C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7FF23D3-7307-7A4A-6471-3CF53718D73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FB9B179-44C2-ED5B-F341-86A91C35F1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6E43B-553D-4B9B-9676-876B5770857C}" type="datetimeFigureOut">
              <a:rPr lang="en-CA" smtClean="0"/>
              <a:t>2026-02-13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6002B9-BB06-A727-F851-AEE1857F54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102C52-C0B0-9E1C-D0FC-5A2DADDD13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113E3-FE1E-4FA3-A873-D5A7B8769F2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402926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0EEA172-46EB-3104-62F2-DBC50A7C44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7FE2D2-2CA7-8BC9-D4EB-9B7AD8AF82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0C339E-B118-0CA9-5571-DFC735D91BB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236E43B-553D-4B9B-9676-876B5770857C}" type="datetimeFigureOut">
              <a:rPr lang="en-CA" smtClean="0"/>
              <a:t>2026-02-13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2FA230-8089-0768-C931-9303373A6E1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4B37B8-1A55-3FAF-431B-9DBC997D5A8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6E113E3-FE1E-4FA3-A873-D5A7B8769F2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322796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9268E4B4-703A-D6A2-9D6F-8B11D2A896BF}"/>
              </a:ext>
            </a:extLst>
          </p:cNvPr>
          <p:cNvGrpSpPr/>
          <p:nvPr/>
        </p:nvGrpSpPr>
        <p:grpSpPr>
          <a:xfrm>
            <a:off x="118963" y="-36007"/>
            <a:ext cx="7051984" cy="6715126"/>
            <a:chOff x="118963" y="-36007"/>
            <a:chExt cx="7051984" cy="6715126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0E73BE56-B05E-EDF8-86C2-61661BCCAA8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r="74776" b="74787"/>
            <a:stretch>
              <a:fillRect/>
            </a:stretch>
          </p:blipFill>
          <p:spPr>
            <a:xfrm>
              <a:off x="342101" y="212029"/>
              <a:ext cx="1408640" cy="1405053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D8613677-46CA-43BE-6DCB-E97A164FF57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24580" r="50196" b="74787"/>
            <a:stretch>
              <a:fillRect/>
            </a:stretch>
          </p:blipFill>
          <p:spPr>
            <a:xfrm>
              <a:off x="2109762" y="212029"/>
              <a:ext cx="1408641" cy="1405053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EC0E803C-B185-21E4-C858-AABF67C4AA2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49618" r="25157" b="74787"/>
            <a:stretch>
              <a:fillRect/>
            </a:stretch>
          </p:blipFill>
          <p:spPr>
            <a:xfrm>
              <a:off x="3877424" y="212028"/>
              <a:ext cx="1408640" cy="1405053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D785E7FA-BC99-09BB-CBFF-9760AEC9D7C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t="24613" r="74776" b="50174"/>
            <a:stretch>
              <a:fillRect/>
            </a:stretch>
          </p:blipFill>
          <p:spPr>
            <a:xfrm>
              <a:off x="342101" y="1820365"/>
              <a:ext cx="1408640" cy="1405053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08CB8C1F-0850-4E3C-0CE7-A59ECB1D4E6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t="75387" r="74776"/>
            <a:stretch>
              <a:fillRect/>
            </a:stretch>
          </p:blipFill>
          <p:spPr>
            <a:xfrm>
              <a:off x="342101" y="5059342"/>
              <a:ext cx="1408640" cy="1371600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A6991AE6-B1E5-7BC4-05E9-7E27C7AC080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t="49625" r="74776" b="24763"/>
            <a:stretch>
              <a:fillRect/>
            </a:stretch>
          </p:blipFill>
          <p:spPr>
            <a:xfrm>
              <a:off x="342101" y="3428702"/>
              <a:ext cx="1408640" cy="1427356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5EDBC3C1-7418-385C-36A5-A4603A75D96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24580" t="50380" r="50196" b="24408"/>
            <a:stretch>
              <a:fillRect/>
            </a:stretch>
          </p:blipFill>
          <p:spPr>
            <a:xfrm>
              <a:off x="2113739" y="3468388"/>
              <a:ext cx="1408641" cy="1405053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0DBA9BCB-BB6C-EDB0-0FED-BC59B8774C1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24580" t="75387" r="50196"/>
            <a:stretch>
              <a:fillRect/>
            </a:stretch>
          </p:blipFill>
          <p:spPr>
            <a:xfrm>
              <a:off x="2109761" y="5059341"/>
              <a:ext cx="1408641" cy="1371601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EE71A097-90D1-95A0-FF31-9FFDFD3EA81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24580" t="25413" r="50196" b="49374"/>
            <a:stretch>
              <a:fillRect/>
            </a:stretch>
          </p:blipFill>
          <p:spPr>
            <a:xfrm>
              <a:off x="2109761" y="1840208"/>
              <a:ext cx="1408641" cy="1405053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72B93ED9-CFFD-3A5E-E9EE-EAD37164588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74776" b="74787"/>
            <a:stretch>
              <a:fillRect/>
            </a:stretch>
          </p:blipFill>
          <p:spPr>
            <a:xfrm>
              <a:off x="5645085" y="212028"/>
              <a:ext cx="1408641" cy="1405053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969C3DBA-EFB3-A0FF-6900-22A89D53199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49618" t="75099" r="25157"/>
            <a:stretch>
              <a:fillRect/>
            </a:stretch>
          </p:blipFill>
          <p:spPr>
            <a:xfrm>
              <a:off x="3877424" y="5059341"/>
              <a:ext cx="1408640" cy="1387670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9FC531B5-2A61-5A9E-4A52-3C8670D8977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49618" t="50354" r="25157" b="24745"/>
            <a:stretch>
              <a:fillRect/>
            </a:stretch>
          </p:blipFill>
          <p:spPr>
            <a:xfrm>
              <a:off x="3885378" y="3417753"/>
              <a:ext cx="1408640" cy="1387670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2C6B7227-DB44-310C-2434-18A40807BF1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49618" t="25214" r="25157" b="49173"/>
            <a:stretch>
              <a:fillRect/>
            </a:stretch>
          </p:blipFill>
          <p:spPr>
            <a:xfrm>
              <a:off x="3877424" y="1798062"/>
              <a:ext cx="1408640" cy="1427356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BEBA52E5-C4F7-D675-3256-31C094F6EDF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74776" t="75387"/>
            <a:stretch>
              <a:fillRect/>
            </a:stretch>
          </p:blipFill>
          <p:spPr>
            <a:xfrm>
              <a:off x="5645083" y="5059340"/>
              <a:ext cx="1408641" cy="1371601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492101DE-4723-F4DB-68AF-71ABFF1E4B1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74776" t="25213" b="49174"/>
            <a:stretch>
              <a:fillRect/>
            </a:stretch>
          </p:blipFill>
          <p:spPr>
            <a:xfrm>
              <a:off x="5645085" y="1798061"/>
              <a:ext cx="1408641" cy="1427357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FFC87F99-85FD-FE5A-5B1C-05E74ADC76D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74776" t="50000" b="24787"/>
            <a:stretch>
              <a:fillRect/>
            </a:stretch>
          </p:blipFill>
          <p:spPr>
            <a:xfrm>
              <a:off x="5645084" y="3400370"/>
              <a:ext cx="1408641" cy="1405053"/>
            </a:xfrm>
            <a:prstGeom prst="rect">
              <a:avLst/>
            </a:prstGeom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889226BC-70E9-3BFE-22A7-F2774906BAC9}"/>
                </a:ext>
              </a:extLst>
            </p:cNvPr>
            <p:cNvSpPr txBox="1"/>
            <p:nvPr/>
          </p:nvSpPr>
          <p:spPr>
            <a:xfrm rot="16200000">
              <a:off x="-588999" y="671956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 dirty="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FF9111DA-F1AE-4528-A62F-EF2DB70220B1}"/>
                </a:ext>
              </a:extLst>
            </p:cNvPr>
            <p:cNvSpPr txBox="1"/>
            <p:nvPr/>
          </p:nvSpPr>
          <p:spPr>
            <a:xfrm rot="16200000">
              <a:off x="-588999" y="2346451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30ABF12F-2853-3544-983C-807A4A11FC00}"/>
                </a:ext>
              </a:extLst>
            </p:cNvPr>
            <p:cNvSpPr txBox="1"/>
            <p:nvPr/>
          </p:nvSpPr>
          <p:spPr>
            <a:xfrm rot="16200000">
              <a:off x="-588999" y="4018660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62D4F1AA-182D-7256-3020-C7EEB8667DB5}"/>
                </a:ext>
              </a:extLst>
            </p:cNvPr>
            <p:cNvSpPr txBox="1"/>
            <p:nvPr/>
          </p:nvSpPr>
          <p:spPr>
            <a:xfrm rot="16200000">
              <a:off x="-588999" y="5714872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6ED13BE0-1DC1-4BFC-CA3E-8DE6AC4897FD}"/>
                </a:ext>
              </a:extLst>
            </p:cNvPr>
            <p:cNvSpPr txBox="1"/>
            <p:nvPr/>
          </p:nvSpPr>
          <p:spPr>
            <a:xfrm rot="16200000">
              <a:off x="1182639" y="705103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 dirty="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5BC1C9EB-1E94-8A8D-B498-05BBCF88F402}"/>
                </a:ext>
              </a:extLst>
            </p:cNvPr>
            <p:cNvSpPr txBox="1"/>
            <p:nvPr/>
          </p:nvSpPr>
          <p:spPr>
            <a:xfrm rot="16200000">
              <a:off x="1182639" y="2379598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478B7F37-B401-AC13-E173-12CEF56BFEF0}"/>
                </a:ext>
              </a:extLst>
            </p:cNvPr>
            <p:cNvSpPr txBox="1"/>
            <p:nvPr/>
          </p:nvSpPr>
          <p:spPr>
            <a:xfrm rot="16200000">
              <a:off x="1182639" y="4051807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7F2469B2-EADC-9127-7294-287FA4AA7512}"/>
                </a:ext>
              </a:extLst>
            </p:cNvPr>
            <p:cNvSpPr txBox="1"/>
            <p:nvPr/>
          </p:nvSpPr>
          <p:spPr>
            <a:xfrm rot="16200000">
              <a:off x="1182639" y="5748019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A2EFE775-25B5-24D0-C5B7-7ADF2B798980}"/>
                </a:ext>
              </a:extLst>
            </p:cNvPr>
            <p:cNvSpPr txBox="1"/>
            <p:nvPr/>
          </p:nvSpPr>
          <p:spPr>
            <a:xfrm rot="16200000">
              <a:off x="2987962" y="671955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 dirty="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D3810D28-B795-8375-BFAD-962CFAB69F95}"/>
                </a:ext>
              </a:extLst>
            </p:cNvPr>
            <p:cNvSpPr txBox="1"/>
            <p:nvPr/>
          </p:nvSpPr>
          <p:spPr>
            <a:xfrm rot="16200000">
              <a:off x="2987962" y="2346450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1D8E9308-0D0A-889A-C31C-812C6DEDCAF9}"/>
                </a:ext>
              </a:extLst>
            </p:cNvPr>
            <p:cNvSpPr txBox="1"/>
            <p:nvPr/>
          </p:nvSpPr>
          <p:spPr>
            <a:xfrm rot="16200000">
              <a:off x="2987962" y="4018659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15A99470-0A13-1665-3B1E-DD72D67D3C6A}"/>
                </a:ext>
              </a:extLst>
            </p:cNvPr>
            <p:cNvSpPr txBox="1"/>
            <p:nvPr/>
          </p:nvSpPr>
          <p:spPr>
            <a:xfrm rot="16200000">
              <a:off x="2987962" y="5714871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3F8D0B5F-5909-5FA6-95A5-E28839C25CAD}"/>
                </a:ext>
              </a:extLst>
            </p:cNvPr>
            <p:cNvSpPr txBox="1"/>
            <p:nvPr/>
          </p:nvSpPr>
          <p:spPr>
            <a:xfrm rot="16200000">
              <a:off x="4733872" y="671955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 dirty="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86795099-067A-BD56-A8FF-0DE7699D3654}"/>
                </a:ext>
              </a:extLst>
            </p:cNvPr>
            <p:cNvSpPr txBox="1"/>
            <p:nvPr/>
          </p:nvSpPr>
          <p:spPr>
            <a:xfrm rot="16200000">
              <a:off x="4733872" y="2346450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0EA631CF-C55E-4B66-4E59-FA42FBAF5C4E}"/>
                </a:ext>
              </a:extLst>
            </p:cNvPr>
            <p:cNvSpPr txBox="1"/>
            <p:nvPr/>
          </p:nvSpPr>
          <p:spPr>
            <a:xfrm rot="16200000">
              <a:off x="4733872" y="4018659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992EE1BA-4374-FD8F-4E3A-AD0AABC2BCC5}"/>
                </a:ext>
              </a:extLst>
            </p:cNvPr>
            <p:cNvSpPr txBox="1"/>
            <p:nvPr/>
          </p:nvSpPr>
          <p:spPr>
            <a:xfrm rot="16200000">
              <a:off x="4733872" y="5714871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3C5D1F8D-EE1A-A3F3-A975-D58EAF779135}"/>
                </a:ext>
              </a:extLst>
            </p:cNvPr>
            <p:cNvSpPr txBox="1"/>
            <p:nvPr/>
          </p:nvSpPr>
          <p:spPr>
            <a:xfrm>
              <a:off x="423920" y="1581262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 dirty="0">
                  <a:latin typeface="+mj-lt"/>
                </a:rPr>
                <a:t>Log</a:t>
              </a:r>
              <a:r>
                <a:rPr lang="en-CA" sz="850" baseline="-25000" dirty="0">
                  <a:latin typeface="+mj-lt"/>
                </a:rPr>
                <a:t>10</a:t>
              </a:r>
              <a:r>
                <a:rPr lang="en-CA" sz="850" dirty="0">
                  <a:latin typeface="+mj-lt"/>
                </a:rPr>
                <a:t> Dose (mg/kg BW/day)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3D3E7204-1AE7-C879-CBE6-76EFD1B81FDD}"/>
                </a:ext>
              </a:extLst>
            </p:cNvPr>
            <p:cNvSpPr txBox="1"/>
            <p:nvPr/>
          </p:nvSpPr>
          <p:spPr>
            <a:xfrm>
              <a:off x="2203336" y="1581262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</a:rPr>
                <a:t>Log</a:t>
              </a:r>
              <a:r>
                <a:rPr lang="en-CA" sz="850" baseline="-25000">
                  <a:latin typeface="+mj-lt"/>
                </a:rPr>
                <a:t>10</a:t>
              </a:r>
              <a:r>
                <a:rPr lang="en-CA" sz="850">
                  <a:latin typeface="+mj-lt"/>
                </a:rPr>
                <a:t> Dose (mg/kg BW/day)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3745E314-5C88-5E79-B32E-C5F7931CD382}"/>
                </a:ext>
              </a:extLst>
            </p:cNvPr>
            <p:cNvSpPr txBox="1"/>
            <p:nvPr/>
          </p:nvSpPr>
          <p:spPr>
            <a:xfrm>
              <a:off x="3982752" y="1581262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</a:rPr>
                <a:t>Log</a:t>
              </a:r>
              <a:r>
                <a:rPr lang="en-CA" sz="850" baseline="-25000">
                  <a:latin typeface="+mj-lt"/>
                </a:rPr>
                <a:t>10</a:t>
              </a:r>
              <a:r>
                <a:rPr lang="en-CA" sz="850">
                  <a:latin typeface="+mj-lt"/>
                </a:rPr>
                <a:t> Dose (mg/kg BW/day)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7475AA98-20EF-B34E-12AB-23C2A6E0BDCF}"/>
                </a:ext>
              </a:extLst>
            </p:cNvPr>
            <p:cNvSpPr txBox="1"/>
            <p:nvPr/>
          </p:nvSpPr>
          <p:spPr>
            <a:xfrm>
              <a:off x="5774201" y="1581262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</a:rPr>
                <a:t>Log</a:t>
              </a:r>
              <a:r>
                <a:rPr lang="en-CA" sz="850" baseline="-25000">
                  <a:latin typeface="+mj-lt"/>
                </a:rPr>
                <a:t>10</a:t>
              </a:r>
              <a:r>
                <a:rPr lang="en-CA" sz="850">
                  <a:latin typeface="+mj-lt"/>
                </a:rPr>
                <a:t> Dose (mg/kg BW/day)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AD035F53-E266-C127-8AAA-9415669DDD15}"/>
                </a:ext>
              </a:extLst>
            </p:cNvPr>
            <p:cNvSpPr txBox="1"/>
            <p:nvPr/>
          </p:nvSpPr>
          <p:spPr>
            <a:xfrm>
              <a:off x="423920" y="3209822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 dirty="0">
                  <a:latin typeface="+mj-lt"/>
                </a:rPr>
                <a:t>Log</a:t>
              </a:r>
              <a:r>
                <a:rPr lang="en-CA" sz="850" baseline="-25000" dirty="0">
                  <a:latin typeface="+mj-lt"/>
                </a:rPr>
                <a:t>10</a:t>
              </a:r>
              <a:r>
                <a:rPr lang="en-CA" sz="850" dirty="0">
                  <a:latin typeface="+mj-lt"/>
                </a:rPr>
                <a:t> Dose (mg/kg BW/day)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9C56BEA3-5CB8-6469-0AFB-959722B8EF5F}"/>
                </a:ext>
              </a:extLst>
            </p:cNvPr>
            <p:cNvSpPr txBox="1"/>
            <p:nvPr/>
          </p:nvSpPr>
          <p:spPr>
            <a:xfrm>
              <a:off x="2203336" y="3209822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</a:rPr>
                <a:t>Log</a:t>
              </a:r>
              <a:r>
                <a:rPr lang="en-CA" sz="850" baseline="-25000">
                  <a:latin typeface="+mj-lt"/>
                </a:rPr>
                <a:t>10</a:t>
              </a:r>
              <a:r>
                <a:rPr lang="en-CA" sz="850">
                  <a:latin typeface="+mj-lt"/>
                </a:rPr>
                <a:t> Dose (mg/kg BW/day)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3D257041-71F0-8C26-B9C0-51EA5B6CB71D}"/>
                </a:ext>
              </a:extLst>
            </p:cNvPr>
            <p:cNvSpPr txBox="1"/>
            <p:nvPr/>
          </p:nvSpPr>
          <p:spPr>
            <a:xfrm>
              <a:off x="3982752" y="3209822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</a:rPr>
                <a:t>Log</a:t>
              </a:r>
              <a:r>
                <a:rPr lang="en-CA" sz="850" baseline="-25000">
                  <a:latin typeface="+mj-lt"/>
                </a:rPr>
                <a:t>10</a:t>
              </a:r>
              <a:r>
                <a:rPr lang="en-CA" sz="850">
                  <a:latin typeface="+mj-lt"/>
                </a:rPr>
                <a:t> Dose (mg/kg BW/day)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51D2B00F-E7EC-A225-9812-C784A86E6B67}"/>
                </a:ext>
              </a:extLst>
            </p:cNvPr>
            <p:cNvSpPr txBox="1"/>
            <p:nvPr/>
          </p:nvSpPr>
          <p:spPr>
            <a:xfrm>
              <a:off x="5774201" y="3209822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</a:rPr>
                <a:t>Log</a:t>
              </a:r>
              <a:r>
                <a:rPr lang="en-CA" sz="850" baseline="-25000">
                  <a:latin typeface="+mj-lt"/>
                </a:rPr>
                <a:t>10</a:t>
              </a:r>
              <a:r>
                <a:rPr lang="en-CA" sz="850">
                  <a:latin typeface="+mj-lt"/>
                </a:rPr>
                <a:t> Dose (mg/kg BW/day)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D0A75C87-D7B3-74A8-C02F-909F69B24C7C}"/>
                </a:ext>
              </a:extLst>
            </p:cNvPr>
            <p:cNvSpPr txBox="1"/>
            <p:nvPr/>
          </p:nvSpPr>
          <p:spPr>
            <a:xfrm>
              <a:off x="423920" y="4837439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 dirty="0">
                  <a:latin typeface="+mj-lt"/>
                </a:rPr>
                <a:t>Log</a:t>
              </a:r>
              <a:r>
                <a:rPr lang="en-CA" sz="850" baseline="-25000" dirty="0">
                  <a:latin typeface="+mj-lt"/>
                </a:rPr>
                <a:t>10</a:t>
              </a:r>
              <a:r>
                <a:rPr lang="en-CA" sz="850" dirty="0">
                  <a:latin typeface="+mj-lt"/>
                </a:rPr>
                <a:t> Dose (mg/kg BW/day)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78EA3A6C-09EB-90F2-4294-99F7F9BDB548}"/>
                </a:ext>
              </a:extLst>
            </p:cNvPr>
            <p:cNvSpPr txBox="1"/>
            <p:nvPr/>
          </p:nvSpPr>
          <p:spPr>
            <a:xfrm>
              <a:off x="2203336" y="4837439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</a:rPr>
                <a:t>Log</a:t>
              </a:r>
              <a:r>
                <a:rPr lang="en-CA" sz="850" baseline="-25000">
                  <a:latin typeface="+mj-lt"/>
                </a:rPr>
                <a:t>10</a:t>
              </a:r>
              <a:r>
                <a:rPr lang="en-CA" sz="850">
                  <a:latin typeface="+mj-lt"/>
                </a:rPr>
                <a:t> Dose (mg/kg BW/day)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71330871-F7A6-E94F-6D4F-1675B3AB8F4C}"/>
                </a:ext>
              </a:extLst>
            </p:cNvPr>
            <p:cNvSpPr txBox="1"/>
            <p:nvPr/>
          </p:nvSpPr>
          <p:spPr>
            <a:xfrm>
              <a:off x="3982752" y="4837439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</a:rPr>
                <a:t>Log</a:t>
              </a:r>
              <a:r>
                <a:rPr lang="en-CA" sz="850" baseline="-25000">
                  <a:latin typeface="+mj-lt"/>
                </a:rPr>
                <a:t>10</a:t>
              </a:r>
              <a:r>
                <a:rPr lang="en-CA" sz="850">
                  <a:latin typeface="+mj-lt"/>
                </a:rPr>
                <a:t> Dose (mg/kg BW/day)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45F31A00-16C2-85D5-88A3-C20A983DBA29}"/>
                </a:ext>
              </a:extLst>
            </p:cNvPr>
            <p:cNvSpPr txBox="1"/>
            <p:nvPr/>
          </p:nvSpPr>
          <p:spPr>
            <a:xfrm>
              <a:off x="5774201" y="4837439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</a:rPr>
                <a:t>Log</a:t>
              </a:r>
              <a:r>
                <a:rPr lang="en-CA" sz="850" baseline="-25000">
                  <a:latin typeface="+mj-lt"/>
                </a:rPr>
                <a:t>10</a:t>
              </a:r>
              <a:r>
                <a:rPr lang="en-CA" sz="850">
                  <a:latin typeface="+mj-lt"/>
                </a:rPr>
                <a:t> Dose (mg/kg BW/day)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4376488C-6412-FEBD-654F-8AFD1B820343}"/>
                </a:ext>
              </a:extLst>
            </p:cNvPr>
            <p:cNvSpPr txBox="1"/>
            <p:nvPr/>
          </p:nvSpPr>
          <p:spPr>
            <a:xfrm>
              <a:off x="423920" y="6434922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 dirty="0">
                  <a:latin typeface="+mj-lt"/>
                </a:rPr>
                <a:t>Log</a:t>
              </a:r>
              <a:r>
                <a:rPr lang="en-CA" sz="850" baseline="-25000" dirty="0">
                  <a:latin typeface="+mj-lt"/>
                </a:rPr>
                <a:t>10</a:t>
              </a:r>
              <a:r>
                <a:rPr lang="en-CA" sz="850" dirty="0">
                  <a:latin typeface="+mj-lt"/>
                </a:rPr>
                <a:t> Dose (mg/kg BW/day)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178E89A8-8C2B-1A3F-A8FF-63320E74014C}"/>
                </a:ext>
              </a:extLst>
            </p:cNvPr>
            <p:cNvSpPr txBox="1"/>
            <p:nvPr/>
          </p:nvSpPr>
          <p:spPr>
            <a:xfrm>
              <a:off x="2203336" y="6434922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</a:rPr>
                <a:t>Log</a:t>
              </a:r>
              <a:r>
                <a:rPr lang="en-CA" sz="850" baseline="-25000">
                  <a:latin typeface="+mj-lt"/>
                </a:rPr>
                <a:t>10</a:t>
              </a:r>
              <a:r>
                <a:rPr lang="en-CA" sz="850">
                  <a:latin typeface="+mj-lt"/>
                </a:rPr>
                <a:t> Dose (mg/kg BW/day)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5D1FA266-ACD3-91E6-5D07-966958CC68DE}"/>
                </a:ext>
              </a:extLst>
            </p:cNvPr>
            <p:cNvSpPr txBox="1"/>
            <p:nvPr/>
          </p:nvSpPr>
          <p:spPr>
            <a:xfrm>
              <a:off x="3982752" y="6434922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</a:rPr>
                <a:t>Log</a:t>
              </a:r>
              <a:r>
                <a:rPr lang="en-CA" sz="850" baseline="-25000">
                  <a:latin typeface="+mj-lt"/>
                </a:rPr>
                <a:t>10</a:t>
              </a:r>
              <a:r>
                <a:rPr lang="en-CA" sz="850">
                  <a:latin typeface="+mj-lt"/>
                </a:rPr>
                <a:t> Dose (mg/kg BW/day)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32533B04-9438-93E3-0D95-B43D906C58AD}"/>
                </a:ext>
              </a:extLst>
            </p:cNvPr>
            <p:cNvSpPr txBox="1"/>
            <p:nvPr/>
          </p:nvSpPr>
          <p:spPr>
            <a:xfrm>
              <a:off x="5774201" y="6434922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</a:rPr>
                <a:t>Log</a:t>
              </a:r>
              <a:r>
                <a:rPr lang="en-CA" sz="850" baseline="-25000">
                  <a:latin typeface="+mj-lt"/>
                </a:rPr>
                <a:t>10</a:t>
              </a:r>
              <a:r>
                <a:rPr lang="en-CA" sz="850">
                  <a:latin typeface="+mj-lt"/>
                </a:rPr>
                <a:t> Dose (mg/kg BW/day)</a:t>
              </a:r>
            </a:p>
          </p:txBody>
        </p:sp>
      </p:grpSp>
      <p:sp>
        <p:nvSpPr>
          <p:cNvPr id="55" name="TextBox 54">
            <a:extLst>
              <a:ext uri="{FF2B5EF4-FFF2-40B4-BE49-F238E27FC236}">
                <a16:creationId xmlns:a16="http://schemas.microsoft.com/office/drawing/2014/main" id="{81D110A6-02F3-F7E2-05CA-710F11C86928}"/>
              </a:ext>
            </a:extLst>
          </p:cNvPr>
          <p:cNvSpPr txBox="1"/>
          <p:nvPr/>
        </p:nvSpPr>
        <p:spPr>
          <a:xfrm>
            <a:off x="7755213" y="1692831"/>
            <a:ext cx="3920490" cy="13501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n-CA" sz="18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1.</a:t>
            </a:r>
            <a:r>
              <a:rPr lang="en-CA" sz="18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PROAST output of the individual dose-response relationships for the 47 </a:t>
            </a:r>
            <a:r>
              <a:rPr lang="en-CA" sz="1800" kern="100" dirty="0" err="1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DupSeq</a:t>
            </a:r>
            <a:r>
              <a:rPr lang="en-CA" sz="18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datasets.</a:t>
            </a:r>
            <a:endParaRPr lang="en-CA" sz="28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12241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Group 49">
            <a:extLst>
              <a:ext uri="{FF2B5EF4-FFF2-40B4-BE49-F238E27FC236}">
                <a16:creationId xmlns:a16="http://schemas.microsoft.com/office/drawing/2014/main" id="{232DA0ED-69E6-BA04-9BC0-0E60E222B4B1}"/>
              </a:ext>
            </a:extLst>
          </p:cNvPr>
          <p:cNvGrpSpPr/>
          <p:nvPr/>
        </p:nvGrpSpPr>
        <p:grpSpPr>
          <a:xfrm>
            <a:off x="125851" y="0"/>
            <a:ext cx="7147538" cy="6717540"/>
            <a:chOff x="125851" y="-91028"/>
            <a:chExt cx="7147538" cy="6717540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2C2782AE-6E32-AA98-3925-7EA1593E88E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r="74488" b="74487"/>
            <a:stretch>
              <a:fillRect/>
            </a:stretch>
          </p:blipFill>
          <p:spPr>
            <a:xfrm>
              <a:off x="348989" y="161692"/>
              <a:ext cx="1424686" cy="1421781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16777D5A-8EA0-1B3A-6549-AE21955B896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74488" b="74487"/>
            <a:stretch>
              <a:fillRect/>
            </a:stretch>
          </p:blipFill>
          <p:spPr>
            <a:xfrm>
              <a:off x="5779691" y="161688"/>
              <a:ext cx="1424687" cy="1421781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2BB0F9C8-89FC-339C-958D-0BDD7F91C41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49969" r="24519" b="74487"/>
            <a:stretch>
              <a:fillRect/>
            </a:stretch>
          </p:blipFill>
          <p:spPr>
            <a:xfrm>
              <a:off x="3925410" y="161688"/>
              <a:ext cx="1424686" cy="1421781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FA78B148-41B3-03C9-0694-26F9F448A51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24501" r="49988" b="74487"/>
            <a:stretch>
              <a:fillRect/>
            </a:stretch>
          </p:blipFill>
          <p:spPr>
            <a:xfrm>
              <a:off x="2128403" y="161688"/>
              <a:ext cx="1424686" cy="1421781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82CA6831-B15A-42B3-173C-68DE21BB892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t="24813" r="74488" b="49674"/>
            <a:stretch>
              <a:fillRect/>
            </a:stretch>
          </p:blipFill>
          <p:spPr>
            <a:xfrm>
              <a:off x="348987" y="1776749"/>
              <a:ext cx="1424686" cy="1421781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ED94FB99-8764-4A5B-3538-AD03995453D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t="74771" r="74488" b="-1460"/>
            <a:stretch>
              <a:fillRect/>
            </a:stretch>
          </p:blipFill>
          <p:spPr>
            <a:xfrm>
              <a:off x="348989" y="5021134"/>
              <a:ext cx="1424686" cy="1487317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A2D9DB9B-8123-1EE9-8855-049472E8DA2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t="49825" r="74488" b="24662"/>
            <a:stretch>
              <a:fillRect/>
            </a:stretch>
          </p:blipFill>
          <p:spPr>
            <a:xfrm>
              <a:off x="348988" y="3377574"/>
              <a:ext cx="1424686" cy="1421781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98BE6014-6359-26E5-BC17-C2F615D861B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24501" t="75543" r="49988" b="-1"/>
            <a:stretch>
              <a:fillRect/>
            </a:stretch>
          </p:blipFill>
          <p:spPr>
            <a:xfrm>
              <a:off x="2128403" y="5024887"/>
              <a:ext cx="1424686" cy="1362974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EF15A7A4-B20E-CE65-7754-39AAB2AC5CF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24501" t="25512" r="49988" b="50272"/>
            <a:stretch>
              <a:fillRect/>
            </a:stretch>
          </p:blipFill>
          <p:spPr>
            <a:xfrm>
              <a:off x="2128401" y="1776746"/>
              <a:ext cx="1424686" cy="1349510"/>
            </a:xfrm>
            <a:prstGeom prst="rect">
              <a:avLst/>
            </a:prstGeom>
          </p:spPr>
        </p:pic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1F0F7C59-C759-0DD5-0320-6B25F0C2DBE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24501" t="50000" r="49988" b="24487"/>
            <a:stretch>
              <a:fillRect/>
            </a:stretch>
          </p:blipFill>
          <p:spPr>
            <a:xfrm>
              <a:off x="2128402" y="3377571"/>
              <a:ext cx="1424686" cy="1421781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C260762D-EE86-5265-F781-551D54C1AAC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49969" t="25513" r="24519" b="50144"/>
            <a:stretch>
              <a:fillRect/>
            </a:stretch>
          </p:blipFill>
          <p:spPr>
            <a:xfrm>
              <a:off x="3925408" y="1773222"/>
              <a:ext cx="1424686" cy="1356559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066B0085-9764-D2E9-6535-2AFC0F42295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49969" t="50000" r="24519" b="24487"/>
            <a:stretch>
              <a:fillRect/>
            </a:stretch>
          </p:blipFill>
          <p:spPr>
            <a:xfrm>
              <a:off x="3925409" y="3377571"/>
              <a:ext cx="1424686" cy="1421781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511AD100-44B7-D751-81E7-428A75F4B73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49969" t="75513" r="24519"/>
            <a:stretch>
              <a:fillRect/>
            </a:stretch>
          </p:blipFill>
          <p:spPr>
            <a:xfrm>
              <a:off x="3925410" y="5021132"/>
              <a:ext cx="1424686" cy="1364620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64552B37-1FC4-3F6C-4C80-AB117B59F54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74488" t="50193" b="25465"/>
            <a:stretch>
              <a:fillRect/>
            </a:stretch>
          </p:blipFill>
          <p:spPr>
            <a:xfrm>
              <a:off x="5779689" y="3377571"/>
              <a:ext cx="1424687" cy="1356559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9F8FA0FF-D37E-CD77-E801-FE94CEFE9A0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74488" t="24550" b="49937"/>
            <a:stretch>
              <a:fillRect/>
            </a:stretch>
          </p:blipFill>
          <p:spPr>
            <a:xfrm>
              <a:off x="5779689" y="1704476"/>
              <a:ext cx="1424687" cy="1421781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30A2655C-C331-E916-5E9A-66594630CBB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74488" t="75513"/>
            <a:stretch>
              <a:fillRect/>
            </a:stretch>
          </p:blipFill>
          <p:spPr>
            <a:xfrm>
              <a:off x="5779689" y="5021132"/>
              <a:ext cx="1424687" cy="1364621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E46850F0-950C-15B1-7D87-32E5FFBFB697}"/>
                </a:ext>
              </a:extLst>
            </p:cNvPr>
            <p:cNvSpPr txBox="1"/>
            <p:nvPr/>
          </p:nvSpPr>
          <p:spPr>
            <a:xfrm rot="16200000">
              <a:off x="-582111" y="616938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 dirty="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8F5AAEF6-E001-3068-7DB3-ECBFD8982AEC}"/>
                </a:ext>
              </a:extLst>
            </p:cNvPr>
            <p:cNvSpPr txBox="1"/>
            <p:nvPr/>
          </p:nvSpPr>
          <p:spPr>
            <a:xfrm rot="16200000">
              <a:off x="-582111" y="2291433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B3B50C8A-44A5-5347-A75E-CD0F03CD6A84}"/>
                </a:ext>
              </a:extLst>
            </p:cNvPr>
            <p:cNvSpPr txBox="1"/>
            <p:nvPr/>
          </p:nvSpPr>
          <p:spPr>
            <a:xfrm rot="16200000">
              <a:off x="-582111" y="3963642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C96D0935-8323-5358-A18C-EC172652CA5A}"/>
                </a:ext>
              </a:extLst>
            </p:cNvPr>
            <p:cNvSpPr txBox="1"/>
            <p:nvPr/>
          </p:nvSpPr>
          <p:spPr>
            <a:xfrm rot="16200000">
              <a:off x="-582111" y="5659854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2B3E1D87-4AC8-2CC7-7A26-4242AF137F64}"/>
                </a:ext>
              </a:extLst>
            </p:cNvPr>
            <p:cNvSpPr txBox="1"/>
            <p:nvPr/>
          </p:nvSpPr>
          <p:spPr>
            <a:xfrm rot="16200000">
              <a:off x="1194521" y="616934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 dirty="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B5DA85BB-F323-EE00-A849-2B44CE54B94B}"/>
                </a:ext>
              </a:extLst>
            </p:cNvPr>
            <p:cNvSpPr txBox="1"/>
            <p:nvPr/>
          </p:nvSpPr>
          <p:spPr>
            <a:xfrm rot="16200000">
              <a:off x="1194521" y="2291429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92D4F253-4BD3-7BFB-23DE-247393AFE676}"/>
                </a:ext>
              </a:extLst>
            </p:cNvPr>
            <p:cNvSpPr txBox="1"/>
            <p:nvPr/>
          </p:nvSpPr>
          <p:spPr>
            <a:xfrm rot="16200000">
              <a:off x="1194521" y="3963638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B09CAF13-A54C-9950-3E31-EB8C3D0731D4}"/>
                </a:ext>
              </a:extLst>
            </p:cNvPr>
            <p:cNvSpPr txBox="1"/>
            <p:nvPr/>
          </p:nvSpPr>
          <p:spPr>
            <a:xfrm rot="16200000">
              <a:off x="1194521" y="5659850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DA8197D0-C1EE-BFF7-677D-F3E68D21092B}"/>
                </a:ext>
              </a:extLst>
            </p:cNvPr>
            <p:cNvSpPr txBox="1"/>
            <p:nvPr/>
          </p:nvSpPr>
          <p:spPr>
            <a:xfrm rot="16200000">
              <a:off x="2997088" y="616934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 dirty="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DD540DE6-E481-E566-B717-D0B50561B084}"/>
                </a:ext>
              </a:extLst>
            </p:cNvPr>
            <p:cNvSpPr txBox="1"/>
            <p:nvPr/>
          </p:nvSpPr>
          <p:spPr>
            <a:xfrm rot="16200000">
              <a:off x="2997088" y="2291429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EA2A198A-BB9C-143F-C664-FD5741A5E1DF}"/>
                </a:ext>
              </a:extLst>
            </p:cNvPr>
            <p:cNvSpPr txBox="1"/>
            <p:nvPr/>
          </p:nvSpPr>
          <p:spPr>
            <a:xfrm rot="16200000">
              <a:off x="2997088" y="3963638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B622213F-A8AF-6634-988B-A84657C7D80F}"/>
                </a:ext>
              </a:extLst>
            </p:cNvPr>
            <p:cNvSpPr txBox="1"/>
            <p:nvPr/>
          </p:nvSpPr>
          <p:spPr>
            <a:xfrm rot="16200000">
              <a:off x="2997088" y="5659850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E7A1A66E-EEEC-7D1F-0A01-99A50BF8C839}"/>
                </a:ext>
              </a:extLst>
            </p:cNvPr>
            <p:cNvSpPr txBox="1"/>
            <p:nvPr/>
          </p:nvSpPr>
          <p:spPr>
            <a:xfrm rot="16200000">
              <a:off x="4856928" y="616934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 dirty="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EB648578-9D43-3BE2-C445-A7F778A9CCFB}"/>
                </a:ext>
              </a:extLst>
            </p:cNvPr>
            <p:cNvSpPr txBox="1"/>
            <p:nvPr/>
          </p:nvSpPr>
          <p:spPr>
            <a:xfrm rot="16200000">
              <a:off x="4856928" y="2291429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3CB2EB49-F595-6C39-82A3-F43F5622C23B}"/>
                </a:ext>
              </a:extLst>
            </p:cNvPr>
            <p:cNvSpPr txBox="1"/>
            <p:nvPr/>
          </p:nvSpPr>
          <p:spPr>
            <a:xfrm rot="16200000">
              <a:off x="4856928" y="3963638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48A485E9-2B79-8C7F-B20E-85C250C6EBAA}"/>
                </a:ext>
              </a:extLst>
            </p:cNvPr>
            <p:cNvSpPr txBox="1"/>
            <p:nvPr/>
          </p:nvSpPr>
          <p:spPr>
            <a:xfrm rot="16200000">
              <a:off x="4856928" y="5659850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A52C4A0C-D9B2-0556-F228-7943EC293E47}"/>
                </a:ext>
              </a:extLst>
            </p:cNvPr>
            <p:cNvSpPr txBox="1"/>
            <p:nvPr/>
          </p:nvSpPr>
          <p:spPr>
            <a:xfrm>
              <a:off x="457351" y="1539066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 dirty="0">
                  <a:latin typeface="+mj-lt"/>
                </a:rPr>
                <a:t>Log</a:t>
              </a:r>
              <a:r>
                <a:rPr lang="en-CA" sz="850" baseline="-25000" dirty="0">
                  <a:latin typeface="+mj-lt"/>
                </a:rPr>
                <a:t>10</a:t>
              </a:r>
              <a:r>
                <a:rPr lang="en-CA" sz="850" dirty="0">
                  <a:latin typeface="+mj-lt"/>
                </a:rPr>
                <a:t> Dose (mg/kg BW/day)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E33581F3-3998-7193-0B48-BFDADCBDC133}"/>
                </a:ext>
              </a:extLst>
            </p:cNvPr>
            <p:cNvSpPr txBox="1"/>
            <p:nvPr/>
          </p:nvSpPr>
          <p:spPr>
            <a:xfrm>
              <a:off x="2236767" y="1539066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</a:rPr>
                <a:t>Log</a:t>
              </a:r>
              <a:r>
                <a:rPr lang="en-CA" sz="850" baseline="-25000">
                  <a:latin typeface="+mj-lt"/>
                </a:rPr>
                <a:t>10</a:t>
              </a:r>
              <a:r>
                <a:rPr lang="en-CA" sz="850">
                  <a:latin typeface="+mj-lt"/>
                </a:rPr>
                <a:t> Dose (mg/kg BW/day)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AC1EF9D4-E333-95B5-2B00-684C60ABC359}"/>
                </a:ext>
              </a:extLst>
            </p:cNvPr>
            <p:cNvSpPr txBox="1"/>
            <p:nvPr/>
          </p:nvSpPr>
          <p:spPr>
            <a:xfrm>
              <a:off x="4016183" y="1539066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</a:rPr>
                <a:t>Log</a:t>
              </a:r>
              <a:r>
                <a:rPr lang="en-CA" sz="850" baseline="-25000">
                  <a:latin typeface="+mj-lt"/>
                </a:rPr>
                <a:t>10</a:t>
              </a:r>
              <a:r>
                <a:rPr lang="en-CA" sz="850">
                  <a:latin typeface="+mj-lt"/>
                </a:rPr>
                <a:t> Dose (mg/kg BW/day)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2B42D4B9-0EE3-A1F0-53CC-C2D98094BA08}"/>
                </a:ext>
              </a:extLst>
            </p:cNvPr>
            <p:cNvSpPr txBox="1"/>
            <p:nvPr/>
          </p:nvSpPr>
          <p:spPr>
            <a:xfrm>
              <a:off x="5876643" y="1539066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 dirty="0">
                  <a:latin typeface="+mj-lt"/>
                </a:rPr>
                <a:t>Log</a:t>
              </a:r>
              <a:r>
                <a:rPr lang="en-CA" sz="850" baseline="-25000" dirty="0">
                  <a:latin typeface="+mj-lt"/>
                </a:rPr>
                <a:t>10</a:t>
              </a:r>
              <a:r>
                <a:rPr lang="en-CA" sz="850" dirty="0">
                  <a:latin typeface="+mj-lt"/>
                </a:rPr>
                <a:t> Dose (mg/kg BW/day)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0BA66F2B-49D5-7AFB-83AE-2C11C9EA7CC1}"/>
                </a:ext>
              </a:extLst>
            </p:cNvPr>
            <p:cNvSpPr txBox="1"/>
            <p:nvPr/>
          </p:nvSpPr>
          <p:spPr>
            <a:xfrm>
              <a:off x="457349" y="3132178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 dirty="0">
                  <a:latin typeface="+mj-lt"/>
                </a:rPr>
                <a:t>Log</a:t>
              </a:r>
              <a:r>
                <a:rPr lang="en-CA" sz="850" baseline="-25000" dirty="0">
                  <a:latin typeface="+mj-lt"/>
                </a:rPr>
                <a:t>10</a:t>
              </a:r>
              <a:r>
                <a:rPr lang="en-CA" sz="850" dirty="0">
                  <a:latin typeface="+mj-lt"/>
                </a:rPr>
                <a:t> Dose (mg/kg BW/day)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2605399B-2D51-884A-33D8-B603928F9F35}"/>
                </a:ext>
              </a:extLst>
            </p:cNvPr>
            <p:cNvSpPr txBox="1"/>
            <p:nvPr/>
          </p:nvSpPr>
          <p:spPr>
            <a:xfrm>
              <a:off x="2236765" y="3132178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</a:rPr>
                <a:t>Log</a:t>
              </a:r>
              <a:r>
                <a:rPr lang="en-CA" sz="850" baseline="-25000">
                  <a:latin typeface="+mj-lt"/>
                </a:rPr>
                <a:t>10</a:t>
              </a:r>
              <a:r>
                <a:rPr lang="en-CA" sz="850">
                  <a:latin typeface="+mj-lt"/>
                </a:rPr>
                <a:t> Dose (mg/kg BW/day)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617BF916-E5E1-6E0C-2DA6-5DB738BD370D}"/>
                </a:ext>
              </a:extLst>
            </p:cNvPr>
            <p:cNvSpPr txBox="1"/>
            <p:nvPr/>
          </p:nvSpPr>
          <p:spPr>
            <a:xfrm>
              <a:off x="4016181" y="3132178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</a:rPr>
                <a:t>Log</a:t>
              </a:r>
              <a:r>
                <a:rPr lang="en-CA" sz="850" baseline="-25000">
                  <a:latin typeface="+mj-lt"/>
                </a:rPr>
                <a:t>10</a:t>
              </a:r>
              <a:r>
                <a:rPr lang="en-CA" sz="850">
                  <a:latin typeface="+mj-lt"/>
                </a:rPr>
                <a:t> Dose (mg/kg BW/day)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2499C559-F684-6C7B-03D8-37E39F0304F7}"/>
                </a:ext>
              </a:extLst>
            </p:cNvPr>
            <p:cNvSpPr txBox="1"/>
            <p:nvPr/>
          </p:nvSpPr>
          <p:spPr>
            <a:xfrm>
              <a:off x="5876641" y="3132178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</a:rPr>
                <a:t>Log</a:t>
              </a:r>
              <a:r>
                <a:rPr lang="en-CA" sz="850" baseline="-25000">
                  <a:latin typeface="+mj-lt"/>
                </a:rPr>
                <a:t>10</a:t>
              </a:r>
              <a:r>
                <a:rPr lang="en-CA" sz="850">
                  <a:latin typeface="+mj-lt"/>
                </a:rPr>
                <a:t> Dose (mg/kg BW/day)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6124AB3C-F97B-333E-D716-EDBF9D2CF094}"/>
                </a:ext>
              </a:extLst>
            </p:cNvPr>
            <p:cNvSpPr txBox="1"/>
            <p:nvPr/>
          </p:nvSpPr>
          <p:spPr>
            <a:xfrm>
              <a:off x="457349" y="4762306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 dirty="0">
                  <a:latin typeface="+mj-lt"/>
                </a:rPr>
                <a:t>Log</a:t>
              </a:r>
              <a:r>
                <a:rPr lang="en-CA" sz="850" baseline="-25000" dirty="0">
                  <a:latin typeface="+mj-lt"/>
                </a:rPr>
                <a:t>10</a:t>
              </a:r>
              <a:r>
                <a:rPr lang="en-CA" sz="850" dirty="0">
                  <a:latin typeface="+mj-lt"/>
                </a:rPr>
                <a:t> Dose (mg/kg BW/day)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1063CFBA-24A7-21C9-0FA5-32F317267428}"/>
                </a:ext>
              </a:extLst>
            </p:cNvPr>
            <p:cNvSpPr txBox="1"/>
            <p:nvPr/>
          </p:nvSpPr>
          <p:spPr>
            <a:xfrm>
              <a:off x="2236765" y="4762306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</a:rPr>
                <a:t>Log</a:t>
              </a:r>
              <a:r>
                <a:rPr lang="en-CA" sz="850" baseline="-25000">
                  <a:latin typeface="+mj-lt"/>
                </a:rPr>
                <a:t>10</a:t>
              </a:r>
              <a:r>
                <a:rPr lang="en-CA" sz="850">
                  <a:latin typeface="+mj-lt"/>
                </a:rPr>
                <a:t> Dose (mg/kg BW/day)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837CC163-7497-B972-2CF0-F369759DBD1F}"/>
                </a:ext>
              </a:extLst>
            </p:cNvPr>
            <p:cNvSpPr txBox="1"/>
            <p:nvPr/>
          </p:nvSpPr>
          <p:spPr>
            <a:xfrm>
              <a:off x="4016181" y="4762306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</a:rPr>
                <a:t>Log</a:t>
              </a:r>
              <a:r>
                <a:rPr lang="en-CA" sz="850" baseline="-25000">
                  <a:latin typeface="+mj-lt"/>
                </a:rPr>
                <a:t>10</a:t>
              </a:r>
              <a:r>
                <a:rPr lang="en-CA" sz="850">
                  <a:latin typeface="+mj-lt"/>
                </a:rPr>
                <a:t> Dose (mg/kg BW/day)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7AAF4515-4A6B-B899-155A-BDE9DB066CDC}"/>
                </a:ext>
              </a:extLst>
            </p:cNvPr>
            <p:cNvSpPr txBox="1"/>
            <p:nvPr/>
          </p:nvSpPr>
          <p:spPr>
            <a:xfrm>
              <a:off x="5876641" y="4762306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</a:rPr>
                <a:t>Log</a:t>
              </a:r>
              <a:r>
                <a:rPr lang="en-CA" sz="850" baseline="-25000">
                  <a:latin typeface="+mj-lt"/>
                </a:rPr>
                <a:t>10</a:t>
              </a:r>
              <a:r>
                <a:rPr lang="en-CA" sz="850">
                  <a:latin typeface="+mj-lt"/>
                </a:rPr>
                <a:t> Dose (mg/kg BW/day)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C93DFF94-8DDD-1FFF-E19C-B001229E7D45}"/>
                </a:ext>
              </a:extLst>
            </p:cNvPr>
            <p:cNvSpPr txBox="1"/>
            <p:nvPr/>
          </p:nvSpPr>
          <p:spPr>
            <a:xfrm>
              <a:off x="457349" y="6403374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 dirty="0">
                  <a:latin typeface="+mj-lt"/>
                </a:rPr>
                <a:t>Log</a:t>
              </a:r>
              <a:r>
                <a:rPr lang="en-CA" sz="850" baseline="-25000" dirty="0">
                  <a:latin typeface="+mj-lt"/>
                </a:rPr>
                <a:t>10</a:t>
              </a:r>
              <a:r>
                <a:rPr lang="en-CA" sz="850" dirty="0">
                  <a:latin typeface="+mj-lt"/>
                </a:rPr>
                <a:t> Dose (mg/kg BW/day)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49D4C6D0-533C-C235-2755-BD7C9BFF9CE6}"/>
                </a:ext>
              </a:extLst>
            </p:cNvPr>
            <p:cNvSpPr txBox="1"/>
            <p:nvPr/>
          </p:nvSpPr>
          <p:spPr>
            <a:xfrm>
              <a:off x="2236765" y="6403374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</a:rPr>
                <a:t>Log</a:t>
              </a:r>
              <a:r>
                <a:rPr lang="en-CA" sz="850" baseline="-25000">
                  <a:latin typeface="+mj-lt"/>
                </a:rPr>
                <a:t>10</a:t>
              </a:r>
              <a:r>
                <a:rPr lang="en-CA" sz="850">
                  <a:latin typeface="+mj-lt"/>
                </a:rPr>
                <a:t> Dose (mg/kg BW/day)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5FC5C256-5B4C-8831-F8D4-C2B5828F699F}"/>
                </a:ext>
              </a:extLst>
            </p:cNvPr>
            <p:cNvSpPr txBox="1"/>
            <p:nvPr/>
          </p:nvSpPr>
          <p:spPr>
            <a:xfrm>
              <a:off x="4016181" y="6403374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</a:rPr>
                <a:t>Log</a:t>
              </a:r>
              <a:r>
                <a:rPr lang="en-CA" sz="850" baseline="-25000">
                  <a:latin typeface="+mj-lt"/>
                </a:rPr>
                <a:t>10</a:t>
              </a:r>
              <a:r>
                <a:rPr lang="en-CA" sz="850">
                  <a:latin typeface="+mj-lt"/>
                </a:rPr>
                <a:t> Dose (mg/kg BW/day)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1D1E020E-D462-6EF4-4973-BE06E4DA4BB4}"/>
                </a:ext>
              </a:extLst>
            </p:cNvPr>
            <p:cNvSpPr txBox="1"/>
            <p:nvPr/>
          </p:nvSpPr>
          <p:spPr>
            <a:xfrm>
              <a:off x="5876641" y="6403374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 dirty="0">
                  <a:latin typeface="+mj-lt"/>
                </a:rPr>
                <a:t>Log</a:t>
              </a:r>
              <a:r>
                <a:rPr lang="en-CA" sz="850" baseline="-25000" dirty="0">
                  <a:latin typeface="+mj-lt"/>
                </a:rPr>
                <a:t>10</a:t>
              </a:r>
              <a:r>
                <a:rPr lang="en-CA" sz="850" dirty="0">
                  <a:latin typeface="+mj-lt"/>
                </a:rPr>
                <a:t> Dose (mg/kg BW/day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217597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3" name="Group 52">
            <a:extLst>
              <a:ext uri="{FF2B5EF4-FFF2-40B4-BE49-F238E27FC236}">
                <a16:creationId xmlns:a16="http://schemas.microsoft.com/office/drawing/2014/main" id="{015923B6-589E-7C78-C9EB-F066ECF49C1D}"/>
              </a:ext>
            </a:extLst>
          </p:cNvPr>
          <p:cNvGrpSpPr/>
          <p:nvPr/>
        </p:nvGrpSpPr>
        <p:grpSpPr>
          <a:xfrm>
            <a:off x="172529" y="0"/>
            <a:ext cx="7054323" cy="6740217"/>
            <a:chOff x="0" y="-53437"/>
            <a:chExt cx="7054323" cy="6740217"/>
          </a:xfrm>
        </p:grpSpPr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82E13202-FDDC-8894-F714-DF2362F7F436}"/>
                </a:ext>
              </a:extLst>
            </p:cNvPr>
            <p:cNvSpPr txBox="1"/>
            <p:nvPr/>
          </p:nvSpPr>
          <p:spPr>
            <a:xfrm>
              <a:off x="5644955" y="3156363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 dirty="0">
                  <a:latin typeface="+mj-lt"/>
                </a:rPr>
                <a:t>Log</a:t>
              </a:r>
              <a:r>
                <a:rPr lang="en-CA" sz="850" baseline="-25000" dirty="0">
                  <a:latin typeface="+mj-lt"/>
                </a:rPr>
                <a:t>10</a:t>
              </a:r>
              <a:r>
                <a:rPr lang="en-CA" sz="850" dirty="0">
                  <a:latin typeface="+mj-lt"/>
                </a:rPr>
                <a:t> Dose (mg/kg BW/day)</a:t>
              </a:r>
            </a:p>
          </p:txBody>
        </p:sp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0AB4F6FF-0168-9DEF-49B7-67B8E40B8CB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r="75110" b="74634"/>
            <a:stretch>
              <a:fillRect/>
            </a:stretch>
          </p:blipFill>
          <p:spPr>
            <a:xfrm>
              <a:off x="214542" y="178000"/>
              <a:ext cx="1389971" cy="1413574"/>
            </a:xfrm>
            <a:prstGeom prst="rect">
              <a:avLst/>
            </a:prstGeom>
          </p:spPr>
        </p:pic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6A87D65A-7357-78FD-2087-81C8E36CFA0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24942" r="50169" b="74634"/>
            <a:stretch>
              <a:fillRect/>
            </a:stretch>
          </p:blipFill>
          <p:spPr>
            <a:xfrm>
              <a:off x="2015379" y="172051"/>
              <a:ext cx="1389971" cy="1413574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139B63FC-C0B1-6851-CDF7-62525FB03FF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74989" b="74741"/>
            <a:stretch>
              <a:fillRect/>
            </a:stretch>
          </p:blipFill>
          <p:spPr>
            <a:xfrm>
              <a:off x="5534303" y="178000"/>
              <a:ext cx="1396748" cy="1407625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8ACE67FC-CEA4-F0CD-75DF-8C22853EAF7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50020" r="24968" b="74634"/>
            <a:stretch>
              <a:fillRect/>
            </a:stretch>
          </p:blipFill>
          <p:spPr>
            <a:xfrm>
              <a:off x="3753555" y="172051"/>
              <a:ext cx="1396747" cy="1413574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847F00B7-F22F-A70C-8AD0-D162D2862A4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t="74768" r="75110"/>
            <a:stretch>
              <a:fillRect/>
            </a:stretch>
          </p:blipFill>
          <p:spPr>
            <a:xfrm>
              <a:off x="212913" y="5111905"/>
              <a:ext cx="1389971" cy="1406107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2E882080-C7C7-A320-86C9-78D03D1116F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t="50287" r="75110" b="24481"/>
            <a:stretch>
              <a:fillRect/>
            </a:stretch>
          </p:blipFill>
          <p:spPr>
            <a:xfrm>
              <a:off x="212914" y="3472844"/>
              <a:ext cx="1389971" cy="1406106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20254EE6-472E-F1DF-4FD6-CB3FA631005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t="25263" r="75110" b="49506"/>
            <a:stretch>
              <a:fillRect/>
            </a:stretch>
          </p:blipFill>
          <p:spPr>
            <a:xfrm>
              <a:off x="214303" y="1805076"/>
              <a:ext cx="1389971" cy="1406106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46527B9-372A-B78A-9383-65BBDA3BE8BC}"/>
                </a:ext>
              </a:extLst>
            </p:cNvPr>
            <p:cNvSpPr txBox="1"/>
            <p:nvPr/>
          </p:nvSpPr>
          <p:spPr>
            <a:xfrm rot="16200000">
              <a:off x="-707962" y="660474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 dirty="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AE0132A-C12A-ECCD-C393-A563FD4A9269}"/>
                </a:ext>
              </a:extLst>
            </p:cNvPr>
            <p:cNvSpPr txBox="1"/>
            <p:nvPr/>
          </p:nvSpPr>
          <p:spPr>
            <a:xfrm rot="16200000">
              <a:off x="-707962" y="2334969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0A753D4C-82C3-87A9-9C6A-46F4FE72504D}"/>
                </a:ext>
              </a:extLst>
            </p:cNvPr>
            <p:cNvSpPr txBox="1"/>
            <p:nvPr/>
          </p:nvSpPr>
          <p:spPr>
            <a:xfrm rot="16200000">
              <a:off x="-707962" y="4007178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52F54BC5-F7C0-BDCD-F411-32FADA7B9FFD}"/>
                </a:ext>
              </a:extLst>
            </p:cNvPr>
            <p:cNvSpPr txBox="1"/>
            <p:nvPr/>
          </p:nvSpPr>
          <p:spPr>
            <a:xfrm rot="16200000">
              <a:off x="-707962" y="5703390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0BD748F9-EB55-DA7B-A9C8-D2AC7E35275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24942" t="75388" r="50169"/>
            <a:stretch>
              <a:fillRect/>
            </a:stretch>
          </p:blipFill>
          <p:spPr>
            <a:xfrm>
              <a:off x="2015378" y="5105956"/>
              <a:ext cx="1389971" cy="1371600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95B0E723-5F40-D2EF-EF9A-79C767BB75F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24942" t="50143" r="50169" b="25245"/>
            <a:stretch>
              <a:fillRect/>
            </a:stretch>
          </p:blipFill>
          <p:spPr>
            <a:xfrm>
              <a:off x="2015379" y="3426998"/>
              <a:ext cx="1389971" cy="1371600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68ED1F4D-E26A-DBF7-8848-9E39474B20E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24942" t="24573" r="50169" b="50062"/>
            <a:stretch>
              <a:fillRect/>
            </a:stretch>
          </p:blipFill>
          <p:spPr>
            <a:xfrm>
              <a:off x="2015379" y="1765007"/>
              <a:ext cx="1389971" cy="1413574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9EA910A6-5AD4-DD09-B099-D8BE9F156B64}"/>
                </a:ext>
              </a:extLst>
            </p:cNvPr>
            <p:cNvSpPr txBox="1"/>
            <p:nvPr/>
          </p:nvSpPr>
          <p:spPr>
            <a:xfrm rot="16200000">
              <a:off x="1110855" y="654525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 dirty="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74BD951E-6BAB-1FA2-A220-32D8EBAA78B5}"/>
                </a:ext>
              </a:extLst>
            </p:cNvPr>
            <p:cNvSpPr txBox="1"/>
            <p:nvPr/>
          </p:nvSpPr>
          <p:spPr>
            <a:xfrm rot="16200000">
              <a:off x="1110855" y="2329020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510C1068-C1A6-93AF-2F85-D8C35D78F9EF}"/>
                </a:ext>
              </a:extLst>
            </p:cNvPr>
            <p:cNvSpPr txBox="1"/>
            <p:nvPr/>
          </p:nvSpPr>
          <p:spPr>
            <a:xfrm rot="16200000">
              <a:off x="1110855" y="4001229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348189F3-A8E8-07D4-3309-596781F34048}"/>
                </a:ext>
              </a:extLst>
            </p:cNvPr>
            <p:cNvSpPr txBox="1"/>
            <p:nvPr/>
          </p:nvSpPr>
          <p:spPr>
            <a:xfrm rot="16200000">
              <a:off x="1110855" y="5697441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EFEA3974-9B2B-E4CB-1181-21C08AE049A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50020" t="75388" r="24968"/>
            <a:stretch>
              <a:fillRect/>
            </a:stretch>
          </p:blipFill>
          <p:spPr>
            <a:xfrm>
              <a:off x="3753552" y="5065000"/>
              <a:ext cx="1396747" cy="1371600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4222C9AD-7300-23BD-A676-CF5A7F28B7C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50020" t="50365" r="24968" b="24558"/>
            <a:stretch>
              <a:fillRect/>
            </a:stretch>
          </p:blipFill>
          <p:spPr>
            <a:xfrm>
              <a:off x="3753553" y="3423051"/>
              <a:ext cx="1396747" cy="1397479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1467A21D-9907-0DCD-CB27-CEF17EE9B45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50020" t="25154" r="24968" b="49480"/>
            <a:stretch>
              <a:fillRect/>
            </a:stretch>
          </p:blipFill>
          <p:spPr>
            <a:xfrm>
              <a:off x="3753554" y="1765007"/>
              <a:ext cx="1396747" cy="1413574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2ACB8D9F-CE9B-0E1A-AEFE-7E91A820591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74989" t="24816" b="49818"/>
            <a:stretch>
              <a:fillRect/>
            </a:stretch>
          </p:blipFill>
          <p:spPr>
            <a:xfrm>
              <a:off x="5534303" y="1765007"/>
              <a:ext cx="1396748" cy="1413574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9458CC88-8969-6AAC-9DF1-6DBBD276218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74989" t="49872" b="24762"/>
            <a:stretch>
              <a:fillRect/>
            </a:stretch>
          </p:blipFill>
          <p:spPr>
            <a:xfrm>
              <a:off x="5534303" y="3385024"/>
              <a:ext cx="1396748" cy="1413574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5A428044-4D33-4961-7A60-9C33B6DD28B8}"/>
                </a:ext>
              </a:extLst>
            </p:cNvPr>
            <p:cNvSpPr txBox="1"/>
            <p:nvPr/>
          </p:nvSpPr>
          <p:spPr>
            <a:xfrm>
              <a:off x="319329" y="1530102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 dirty="0">
                  <a:latin typeface="+mj-lt"/>
                </a:rPr>
                <a:t>Log</a:t>
              </a:r>
              <a:r>
                <a:rPr lang="en-CA" sz="850" baseline="-25000" dirty="0">
                  <a:latin typeface="+mj-lt"/>
                </a:rPr>
                <a:t>10</a:t>
              </a:r>
              <a:r>
                <a:rPr lang="en-CA" sz="850" dirty="0">
                  <a:latin typeface="+mj-lt"/>
                </a:rPr>
                <a:t> Dose (mg/kg BW/day)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8E86592F-0464-122C-1ABC-C7874D913516}"/>
                </a:ext>
              </a:extLst>
            </p:cNvPr>
            <p:cNvSpPr txBox="1"/>
            <p:nvPr/>
          </p:nvSpPr>
          <p:spPr>
            <a:xfrm>
              <a:off x="2098745" y="1530102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</a:rPr>
                <a:t>Log</a:t>
              </a:r>
              <a:r>
                <a:rPr lang="en-CA" sz="850" baseline="-25000">
                  <a:latin typeface="+mj-lt"/>
                </a:rPr>
                <a:t>10</a:t>
              </a:r>
              <a:r>
                <a:rPr lang="en-CA" sz="850">
                  <a:latin typeface="+mj-lt"/>
                </a:rPr>
                <a:t> Dose (mg/kg BW/day)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977D835F-4E73-50BF-4C78-FB66056D9DB3}"/>
                </a:ext>
              </a:extLst>
            </p:cNvPr>
            <p:cNvSpPr txBox="1"/>
            <p:nvPr/>
          </p:nvSpPr>
          <p:spPr>
            <a:xfrm>
              <a:off x="3878161" y="1530102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</a:rPr>
                <a:t>Log</a:t>
              </a:r>
              <a:r>
                <a:rPr lang="en-CA" sz="850" baseline="-25000">
                  <a:latin typeface="+mj-lt"/>
                </a:rPr>
                <a:t>10</a:t>
              </a:r>
              <a:r>
                <a:rPr lang="en-CA" sz="850">
                  <a:latin typeface="+mj-lt"/>
                </a:rPr>
                <a:t> Dose (mg/kg BW/day)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4E329D1A-482E-3162-974C-CD48975D2624}"/>
                </a:ext>
              </a:extLst>
            </p:cNvPr>
            <p:cNvSpPr txBox="1"/>
            <p:nvPr/>
          </p:nvSpPr>
          <p:spPr>
            <a:xfrm>
              <a:off x="5657577" y="1530102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 dirty="0">
                  <a:latin typeface="+mj-lt"/>
                </a:rPr>
                <a:t>Log</a:t>
              </a:r>
              <a:r>
                <a:rPr lang="en-CA" sz="850" baseline="-25000" dirty="0">
                  <a:latin typeface="+mj-lt"/>
                </a:rPr>
                <a:t>10</a:t>
              </a:r>
              <a:r>
                <a:rPr lang="en-CA" sz="850" dirty="0">
                  <a:latin typeface="+mj-lt"/>
                </a:rPr>
                <a:t> Dose (mg/kg BW/day)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53D22741-C4D0-4FBF-26AA-6627269774AB}"/>
                </a:ext>
              </a:extLst>
            </p:cNvPr>
            <p:cNvSpPr txBox="1"/>
            <p:nvPr/>
          </p:nvSpPr>
          <p:spPr>
            <a:xfrm>
              <a:off x="306707" y="3156363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 dirty="0">
                  <a:latin typeface="+mj-lt"/>
                </a:rPr>
                <a:t>Log</a:t>
              </a:r>
              <a:r>
                <a:rPr lang="en-CA" sz="850" baseline="-25000" dirty="0">
                  <a:latin typeface="+mj-lt"/>
                </a:rPr>
                <a:t>10</a:t>
              </a:r>
              <a:r>
                <a:rPr lang="en-CA" sz="850" dirty="0">
                  <a:latin typeface="+mj-lt"/>
                </a:rPr>
                <a:t> Dose (mg/kg BW/day)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7B030AAD-AAE3-719D-C079-244763EA8762}"/>
                </a:ext>
              </a:extLst>
            </p:cNvPr>
            <p:cNvSpPr txBox="1"/>
            <p:nvPr/>
          </p:nvSpPr>
          <p:spPr>
            <a:xfrm>
              <a:off x="2086123" y="3156363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</a:rPr>
                <a:t>Log</a:t>
              </a:r>
              <a:r>
                <a:rPr lang="en-CA" sz="850" baseline="-25000">
                  <a:latin typeface="+mj-lt"/>
                </a:rPr>
                <a:t>10</a:t>
              </a:r>
              <a:r>
                <a:rPr lang="en-CA" sz="850">
                  <a:latin typeface="+mj-lt"/>
                </a:rPr>
                <a:t> Dose (mg/kg BW/day)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44DC9E29-D2E1-A8C0-CBFA-046DEFDEF8E7}"/>
                </a:ext>
              </a:extLst>
            </p:cNvPr>
            <p:cNvSpPr txBox="1"/>
            <p:nvPr/>
          </p:nvSpPr>
          <p:spPr>
            <a:xfrm>
              <a:off x="3865539" y="3156363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</a:rPr>
                <a:t>Log</a:t>
              </a:r>
              <a:r>
                <a:rPr lang="en-CA" sz="850" baseline="-25000">
                  <a:latin typeface="+mj-lt"/>
                </a:rPr>
                <a:t>10</a:t>
              </a:r>
              <a:r>
                <a:rPr lang="en-CA" sz="850">
                  <a:latin typeface="+mj-lt"/>
                </a:rPr>
                <a:t> Dose (mg/kg BW/day)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D2C4EDB7-0C56-6CBB-DD18-A1A0E94236BE}"/>
                </a:ext>
              </a:extLst>
            </p:cNvPr>
            <p:cNvSpPr txBox="1"/>
            <p:nvPr/>
          </p:nvSpPr>
          <p:spPr>
            <a:xfrm>
              <a:off x="319329" y="4803506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 dirty="0">
                  <a:latin typeface="+mj-lt"/>
                </a:rPr>
                <a:t>Log</a:t>
              </a:r>
              <a:r>
                <a:rPr lang="en-CA" sz="850" baseline="-25000" dirty="0">
                  <a:latin typeface="+mj-lt"/>
                </a:rPr>
                <a:t>10</a:t>
              </a:r>
              <a:r>
                <a:rPr lang="en-CA" sz="850" dirty="0">
                  <a:latin typeface="+mj-lt"/>
                </a:rPr>
                <a:t> Dose (mg/kg BW/day)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16A58F7D-97AF-D50A-216F-BF7AC655841E}"/>
                </a:ext>
              </a:extLst>
            </p:cNvPr>
            <p:cNvSpPr txBox="1"/>
            <p:nvPr/>
          </p:nvSpPr>
          <p:spPr>
            <a:xfrm>
              <a:off x="2098745" y="4803506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</a:rPr>
                <a:t>Log</a:t>
              </a:r>
              <a:r>
                <a:rPr lang="en-CA" sz="850" baseline="-25000">
                  <a:latin typeface="+mj-lt"/>
                </a:rPr>
                <a:t>10</a:t>
              </a:r>
              <a:r>
                <a:rPr lang="en-CA" sz="850">
                  <a:latin typeface="+mj-lt"/>
                </a:rPr>
                <a:t> Dose (mg/kg BW/day)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5E916ECA-F488-BCEC-D275-043FC875B289}"/>
                </a:ext>
              </a:extLst>
            </p:cNvPr>
            <p:cNvSpPr txBox="1"/>
            <p:nvPr/>
          </p:nvSpPr>
          <p:spPr>
            <a:xfrm>
              <a:off x="3878161" y="4803506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</a:rPr>
                <a:t>Log</a:t>
              </a:r>
              <a:r>
                <a:rPr lang="en-CA" sz="850" baseline="-25000">
                  <a:latin typeface="+mj-lt"/>
                </a:rPr>
                <a:t>10</a:t>
              </a:r>
              <a:r>
                <a:rPr lang="en-CA" sz="850">
                  <a:latin typeface="+mj-lt"/>
                </a:rPr>
                <a:t> Dose (mg/kg BW/day)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143B0E18-0E71-B417-A4E4-2F768D24CACF}"/>
                </a:ext>
              </a:extLst>
            </p:cNvPr>
            <p:cNvSpPr txBox="1"/>
            <p:nvPr/>
          </p:nvSpPr>
          <p:spPr>
            <a:xfrm>
              <a:off x="5657577" y="4803506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 dirty="0">
                  <a:latin typeface="+mj-lt"/>
                </a:rPr>
                <a:t>Log</a:t>
              </a:r>
              <a:r>
                <a:rPr lang="en-CA" sz="850" baseline="-25000" dirty="0">
                  <a:latin typeface="+mj-lt"/>
                </a:rPr>
                <a:t>10</a:t>
              </a:r>
              <a:r>
                <a:rPr lang="en-CA" sz="850" dirty="0">
                  <a:latin typeface="+mj-lt"/>
                </a:rPr>
                <a:t> Dose (mg/kg BW/day)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0A4943B3-B2C2-E7A6-8377-40E672163B43}"/>
                </a:ext>
              </a:extLst>
            </p:cNvPr>
            <p:cNvSpPr txBox="1"/>
            <p:nvPr/>
          </p:nvSpPr>
          <p:spPr>
            <a:xfrm>
              <a:off x="306707" y="6463642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 dirty="0">
                  <a:latin typeface="+mj-lt"/>
                </a:rPr>
                <a:t>Log</a:t>
              </a:r>
              <a:r>
                <a:rPr lang="en-CA" sz="850" baseline="-25000" dirty="0">
                  <a:latin typeface="+mj-lt"/>
                </a:rPr>
                <a:t>10</a:t>
              </a:r>
              <a:r>
                <a:rPr lang="en-CA" sz="850" dirty="0">
                  <a:latin typeface="+mj-lt"/>
                </a:rPr>
                <a:t> Dose (mg/kg BW/day)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962D7A00-B079-360B-983E-BD3577E492D2}"/>
                </a:ext>
              </a:extLst>
            </p:cNvPr>
            <p:cNvSpPr txBox="1"/>
            <p:nvPr/>
          </p:nvSpPr>
          <p:spPr>
            <a:xfrm>
              <a:off x="2086123" y="6463642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</a:rPr>
                <a:t>Log</a:t>
              </a:r>
              <a:r>
                <a:rPr lang="en-CA" sz="850" baseline="-25000">
                  <a:latin typeface="+mj-lt"/>
                </a:rPr>
                <a:t>10</a:t>
              </a:r>
              <a:r>
                <a:rPr lang="en-CA" sz="850">
                  <a:latin typeface="+mj-lt"/>
                </a:rPr>
                <a:t> Dose (mg/kg BW/day)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268383ED-8EA1-5FFF-D377-FFCD45FCFDB1}"/>
                </a:ext>
              </a:extLst>
            </p:cNvPr>
            <p:cNvSpPr txBox="1"/>
            <p:nvPr/>
          </p:nvSpPr>
          <p:spPr>
            <a:xfrm>
              <a:off x="3865539" y="6463642"/>
              <a:ext cx="1396746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</a:rPr>
                <a:t>Log</a:t>
              </a:r>
              <a:r>
                <a:rPr lang="en-CA" sz="850" baseline="-25000">
                  <a:latin typeface="+mj-lt"/>
                </a:rPr>
                <a:t>10</a:t>
              </a:r>
              <a:r>
                <a:rPr lang="en-CA" sz="850">
                  <a:latin typeface="+mj-lt"/>
                </a:rPr>
                <a:t> Dose (mg/kg BW/day)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C038713B-59C0-A549-413F-C741D7ED329C}"/>
                </a:ext>
              </a:extLst>
            </p:cNvPr>
            <p:cNvSpPr txBox="1"/>
            <p:nvPr/>
          </p:nvSpPr>
          <p:spPr>
            <a:xfrm rot="16200000">
              <a:off x="2866629" y="711933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 dirty="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31F348E0-637E-ADEE-30ED-C875B4FE7BA4}"/>
                </a:ext>
              </a:extLst>
            </p:cNvPr>
            <p:cNvSpPr txBox="1"/>
            <p:nvPr/>
          </p:nvSpPr>
          <p:spPr>
            <a:xfrm rot="16200000">
              <a:off x="2866629" y="2386428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8638345D-6831-4800-8859-3F4444E1A207}"/>
                </a:ext>
              </a:extLst>
            </p:cNvPr>
            <p:cNvSpPr txBox="1"/>
            <p:nvPr/>
          </p:nvSpPr>
          <p:spPr>
            <a:xfrm rot="16200000">
              <a:off x="2866629" y="4058637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74C1ADCC-095E-675F-BFF4-A39275741A45}"/>
                </a:ext>
              </a:extLst>
            </p:cNvPr>
            <p:cNvSpPr txBox="1"/>
            <p:nvPr/>
          </p:nvSpPr>
          <p:spPr>
            <a:xfrm rot="16200000">
              <a:off x="2866629" y="5754849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7750FE24-A787-C38B-58FF-EC3E880D3F20}"/>
                </a:ext>
              </a:extLst>
            </p:cNvPr>
            <p:cNvSpPr txBox="1"/>
            <p:nvPr/>
          </p:nvSpPr>
          <p:spPr>
            <a:xfrm rot="16200000">
              <a:off x="4628365" y="711933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 dirty="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 dirty="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CF4E10D6-2666-6130-8977-84924D3E76E1}"/>
                </a:ext>
              </a:extLst>
            </p:cNvPr>
            <p:cNvSpPr txBox="1"/>
            <p:nvPr/>
          </p:nvSpPr>
          <p:spPr>
            <a:xfrm rot="16200000">
              <a:off x="4628365" y="2386428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DE99759B-0374-C42D-2FA1-5BF0F9627BCF}"/>
                </a:ext>
              </a:extLst>
            </p:cNvPr>
            <p:cNvSpPr txBox="1"/>
            <p:nvPr/>
          </p:nvSpPr>
          <p:spPr>
            <a:xfrm rot="16200000">
              <a:off x="4628365" y="4058637"/>
              <a:ext cx="1639062" cy="2231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en-CA" sz="850" baseline="-25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r>
                <a:rPr lang="en-CA" sz="85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 Mutation Frequency x 10</a:t>
              </a:r>
              <a:r>
                <a:rPr lang="en-CA" sz="850" baseline="30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rPr>
                <a:t>-8 </a:t>
              </a:r>
              <a:endParaRPr lang="en-CA" sz="850">
                <a:latin typeface="+mj-lt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667788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>
            <a:extLst>
              <a:ext uri="{FF2B5EF4-FFF2-40B4-BE49-F238E27FC236}">
                <a16:creationId xmlns:a16="http://schemas.microsoft.com/office/drawing/2014/main" id="{C73F4F0E-A613-F12C-9396-2B857E54289F}"/>
              </a:ext>
            </a:extLst>
          </p:cNvPr>
          <p:cNvGrpSpPr/>
          <p:nvPr/>
        </p:nvGrpSpPr>
        <p:grpSpPr>
          <a:xfrm>
            <a:off x="1872388" y="0"/>
            <a:ext cx="6338162" cy="6235384"/>
            <a:chOff x="1872388" y="0"/>
            <a:chExt cx="6338162" cy="6235384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4A3D206F-76DF-C04B-E221-A3DF79A3ADF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62149" y="0"/>
              <a:ext cx="6248401" cy="6235384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D57781CB-EEA7-FDA0-E510-02DE8795E346}"/>
                </a:ext>
              </a:extLst>
            </p:cNvPr>
            <p:cNvGrpSpPr/>
            <p:nvPr/>
          </p:nvGrpSpPr>
          <p:grpSpPr>
            <a:xfrm>
              <a:off x="1872388" y="38761"/>
              <a:ext cx="3535150" cy="5914508"/>
              <a:chOff x="1872388" y="38761"/>
              <a:chExt cx="3535150" cy="5914508"/>
            </a:xfrm>
          </p:grpSpPr>
          <p:grpSp>
            <p:nvGrpSpPr>
              <p:cNvPr id="18" name="Group 17">
                <a:extLst>
                  <a:ext uri="{FF2B5EF4-FFF2-40B4-BE49-F238E27FC236}">
                    <a16:creationId xmlns:a16="http://schemas.microsoft.com/office/drawing/2014/main" id="{39BBD53C-A670-A33A-388E-6BE54FD85919}"/>
                  </a:ext>
                </a:extLst>
              </p:cNvPr>
              <p:cNvGrpSpPr/>
              <p:nvPr/>
            </p:nvGrpSpPr>
            <p:grpSpPr>
              <a:xfrm>
                <a:off x="1872388" y="66314"/>
                <a:ext cx="369332" cy="5886955"/>
                <a:chOff x="1872388" y="66314"/>
                <a:chExt cx="369332" cy="5886955"/>
              </a:xfrm>
            </p:grpSpPr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638819FD-9B57-D3A7-5706-4D64B7CF2EDB}"/>
                    </a:ext>
                  </a:extLst>
                </p:cNvPr>
                <p:cNvSpPr txBox="1"/>
                <p:nvPr/>
              </p:nvSpPr>
              <p:spPr>
                <a:xfrm rot="16200000">
                  <a:off x="1216921" y="729476"/>
                  <a:ext cx="1680268" cy="35394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CA" sz="900">
                      <a:latin typeface="+mj-lt"/>
                      <a:ea typeface="Calibri" panose="020F0502020204030204" pitchFamily="34" charset="0"/>
                      <a:cs typeface="Calibri" panose="020F0502020204030204" pitchFamily="34" charset="0"/>
                    </a:rPr>
                    <a:t>Log</a:t>
                  </a:r>
                  <a:r>
                    <a:rPr lang="en-CA" sz="900" baseline="-25000">
                      <a:latin typeface="+mj-lt"/>
                      <a:ea typeface="Calibri" panose="020F0502020204030204" pitchFamily="34" charset="0"/>
                      <a:cs typeface="Calibri" panose="020F0502020204030204" pitchFamily="34" charset="0"/>
                    </a:rPr>
                    <a:t>10</a:t>
                  </a:r>
                  <a:r>
                    <a:rPr lang="en-CA" sz="900">
                      <a:latin typeface="+mj-lt"/>
                      <a:ea typeface="Calibri" panose="020F0502020204030204" pitchFamily="34" charset="0"/>
                      <a:cs typeface="Calibri" panose="020F0502020204030204" pitchFamily="34" charset="0"/>
                    </a:rPr>
                    <a:t> Mutation Frequency x 10</a:t>
                  </a:r>
                  <a:r>
                    <a:rPr lang="en-CA" sz="900" baseline="30000">
                      <a:latin typeface="+mj-lt"/>
                      <a:ea typeface="Calibri" panose="020F0502020204030204" pitchFamily="34" charset="0"/>
                      <a:cs typeface="Calibri" panose="020F0502020204030204" pitchFamily="34" charset="0"/>
                    </a:rPr>
                    <a:t>-8 </a:t>
                  </a:r>
                  <a:endParaRPr lang="en-CA" sz="900">
                    <a:latin typeface="+mj-lt"/>
                    <a:ea typeface="Calibri" panose="020F0502020204030204" pitchFamily="34" charset="0"/>
                    <a:cs typeface="Calibri" panose="020F0502020204030204" pitchFamily="34" charset="0"/>
                  </a:endParaRPr>
                </a:p>
                <a:p>
                  <a:endParaRPr lang="en-CA" sz="80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7" name="TextBox 6">
                  <a:extLst>
                    <a:ext uri="{FF2B5EF4-FFF2-40B4-BE49-F238E27FC236}">
                      <a16:creationId xmlns:a16="http://schemas.microsoft.com/office/drawing/2014/main" id="{248B5DC3-15F5-AE0E-275D-B5CCAB577360}"/>
                    </a:ext>
                  </a:extLst>
                </p:cNvPr>
                <p:cNvSpPr txBox="1"/>
                <p:nvPr/>
              </p:nvSpPr>
              <p:spPr>
                <a:xfrm rot="16200000">
                  <a:off x="1216921" y="2832819"/>
                  <a:ext cx="1680268" cy="35394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CA" sz="900">
                      <a:latin typeface="+mj-lt"/>
                      <a:ea typeface="Calibri" panose="020F0502020204030204" pitchFamily="34" charset="0"/>
                      <a:cs typeface="Calibri" panose="020F0502020204030204" pitchFamily="34" charset="0"/>
                    </a:rPr>
                    <a:t>Log</a:t>
                  </a:r>
                  <a:r>
                    <a:rPr lang="en-CA" sz="900" baseline="-25000">
                      <a:latin typeface="+mj-lt"/>
                      <a:ea typeface="Calibri" panose="020F0502020204030204" pitchFamily="34" charset="0"/>
                      <a:cs typeface="Calibri" panose="020F0502020204030204" pitchFamily="34" charset="0"/>
                    </a:rPr>
                    <a:t>10</a:t>
                  </a:r>
                  <a:r>
                    <a:rPr lang="en-CA" sz="900">
                      <a:latin typeface="+mj-lt"/>
                      <a:ea typeface="Calibri" panose="020F0502020204030204" pitchFamily="34" charset="0"/>
                      <a:cs typeface="Calibri" panose="020F0502020204030204" pitchFamily="34" charset="0"/>
                    </a:rPr>
                    <a:t> Mutation Frequency x 10</a:t>
                  </a:r>
                  <a:r>
                    <a:rPr lang="en-CA" sz="900" baseline="30000">
                      <a:latin typeface="+mj-lt"/>
                      <a:ea typeface="Calibri" panose="020F0502020204030204" pitchFamily="34" charset="0"/>
                      <a:cs typeface="Calibri" panose="020F0502020204030204" pitchFamily="34" charset="0"/>
                    </a:rPr>
                    <a:t>-8 </a:t>
                  </a:r>
                  <a:endParaRPr lang="en-CA" sz="900">
                    <a:latin typeface="+mj-lt"/>
                    <a:ea typeface="Calibri" panose="020F0502020204030204" pitchFamily="34" charset="0"/>
                    <a:cs typeface="Calibri" panose="020F0502020204030204" pitchFamily="34" charset="0"/>
                  </a:endParaRPr>
                </a:p>
                <a:p>
                  <a:endParaRPr lang="en-CA" sz="80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BFF4B084-145A-0F0C-6CB4-C34EA93351D9}"/>
                    </a:ext>
                  </a:extLst>
                </p:cNvPr>
                <p:cNvSpPr txBox="1"/>
                <p:nvPr/>
              </p:nvSpPr>
              <p:spPr>
                <a:xfrm rot="16200000">
                  <a:off x="1216920" y="4928469"/>
                  <a:ext cx="168026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CA" sz="900">
                      <a:latin typeface="+mj-lt"/>
                      <a:ea typeface="Calibri" panose="020F0502020204030204" pitchFamily="34" charset="0"/>
                      <a:cs typeface="Calibri" panose="020F0502020204030204" pitchFamily="34" charset="0"/>
                    </a:rPr>
                    <a:t>Log</a:t>
                  </a:r>
                  <a:r>
                    <a:rPr lang="en-CA" sz="900" baseline="-25000">
                      <a:latin typeface="+mj-lt"/>
                      <a:ea typeface="Calibri" panose="020F0502020204030204" pitchFamily="34" charset="0"/>
                      <a:cs typeface="Calibri" panose="020F0502020204030204" pitchFamily="34" charset="0"/>
                    </a:rPr>
                    <a:t>10</a:t>
                  </a:r>
                  <a:r>
                    <a:rPr lang="en-CA" sz="900">
                      <a:latin typeface="+mj-lt"/>
                      <a:ea typeface="Calibri" panose="020F0502020204030204" pitchFamily="34" charset="0"/>
                      <a:cs typeface="Calibri" panose="020F0502020204030204" pitchFamily="34" charset="0"/>
                    </a:rPr>
                    <a:t> Mutation Frequency x 10</a:t>
                  </a:r>
                  <a:r>
                    <a:rPr lang="en-CA" sz="900" baseline="30000">
                      <a:latin typeface="+mj-lt"/>
                      <a:ea typeface="Calibri" panose="020F0502020204030204" pitchFamily="34" charset="0"/>
                      <a:cs typeface="Calibri" panose="020F0502020204030204" pitchFamily="34" charset="0"/>
                    </a:rPr>
                    <a:t>-8 </a:t>
                  </a:r>
                  <a:endParaRPr lang="en-CA" sz="900">
                    <a:latin typeface="+mj-lt"/>
                    <a:ea typeface="Calibri" panose="020F0502020204030204" pitchFamily="34" charset="0"/>
                    <a:cs typeface="Calibri" panose="020F0502020204030204" pitchFamily="34" charset="0"/>
                  </a:endParaRPr>
                </a:p>
                <a:p>
                  <a:endParaRPr lang="en-CA" sz="90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</p:grp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8BDB5FFF-A967-EA01-BF48-5BBB4C7A0048}"/>
                  </a:ext>
                </a:extLst>
              </p:cNvPr>
              <p:cNvSpPr txBox="1"/>
              <p:nvPr/>
            </p:nvSpPr>
            <p:spPr>
              <a:xfrm rot="16200000">
                <a:off x="4382738" y="694229"/>
                <a:ext cx="168026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900">
                    <a:latin typeface="+mj-lt"/>
                    <a:ea typeface="Calibri" panose="020F0502020204030204" pitchFamily="34" charset="0"/>
                    <a:cs typeface="Calibri" panose="020F0502020204030204" pitchFamily="34" charset="0"/>
                  </a:rPr>
                  <a:t>Log</a:t>
                </a:r>
                <a:r>
                  <a:rPr lang="en-CA" sz="900" baseline="-25000">
                    <a:latin typeface="+mj-lt"/>
                    <a:ea typeface="Calibri" panose="020F0502020204030204" pitchFamily="34" charset="0"/>
                    <a:cs typeface="Calibri" panose="020F0502020204030204" pitchFamily="34" charset="0"/>
                  </a:rPr>
                  <a:t>10</a:t>
                </a:r>
                <a:r>
                  <a:rPr lang="en-CA" sz="900">
                    <a:latin typeface="+mj-lt"/>
                    <a:ea typeface="Calibri" panose="020F0502020204030204" pitchFamily="34" charset="0"/>
                    <a:cs typeface="Calibri" panose="020F0502020204030204" pitchFamily="34" charset="0"/>
                  </a:rPr>
                  <a:t> Mutation Frequency x 10</a:t>
                </a:r>
                <a:r>
                  <a:rPr lang="en-CA" sz="900" baseline="30000">
                    <a:latin typeface="+mj-lt"/>
                    <a:ea typeface="Calibri" panose="020F0502020204030204" pitchFamily="34" charset="0"/>
                    <a:cs typeface="Calibri" panose="020F0502020204030204" pitchFamily="34" charset="0"/>
                  </a:rPr>
                  <a:t>-8 </a:t>
                </a:r>
                <a:endParaRPr lang="en-CA" sz="9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endParaRPr>
              </a:p>
              <a:p>
                <a:endParaRPr lang="en-CA" sz="90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F8247250-411F-AB95-D735-4C2466B7EF6B}"/>
                  </a:ext>
                </a:extLst>
              </p:cNvPr>
              <p:cNvSpPr txBox="1"/>
              <p:nvPr/>
            </p:nvSpPr>
            <p:spPr>
              <a:xfrm rot="16200000">
                <a:off x="4382738" y="2797572"/>
                <a:ext cx="168026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900">
                    <a:latin typeface="+mj-lt"/>
                    <a:ea typeface="Calibri" panose="020F0502020204030204" pitchFamily="34" charset="0"/>
                    <a:cs typeface="Calibri" panose="020F0502020204030204" pitchFamily="34" charset="0"/>
                  </a:rPr>
                  <a:t>Log</a:t>
                </a:r>
                <a:r>
                  <a:rPr lang="en-CA" sz="900" baseline="-25000">
                    <a:latin typeface="+mj-lt"/>
                    <a:ea typeface="Calibri" panose="020F0502020204030204" pitchFamily="34" charset="0"/>
                    <a:cs typeface="Calibri" panose="020F0502020204030204" pitchFamily="34" charset="0"/>
                  </a:rPr>
                  <a:t>10</a:t>
                </a:r>
                <a:r>
                  <a:rPr lang="en-CA" sz="900">
                    <a:latin typeface="+mj-lt"/>
                    <a:ea typeface="Calibri" panose="020F0502020204030204" pitchFamily="34" charset="0"/>
                    <a:cs typeface="Calibri" panose="020F0502020204030204" pitchFamily="34" charset="0"/>
                  </a:rPr>
                  <a:t> Mutation Frequency x 10</a:t>
                </a:r>
                <a:r>
                  <a:rPr lang="en-CA" sz="900" baseline="30000">
                    <a:latin typeface="+mj-lt"/>
                    <a:ea typeface="Calibri" panose="020F0502020204030204" pitchFamily="34" charset="0"/>
                    <a:cs typeface="Calibri" panose="020F0502020204030204" pitchFamily="34" charset="0"/>
                  </a:rPr>
                  <a:t>-8 </a:t>
                </a:r>
                <a:endParaRPr lang="en-CA" sz="9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endParaRPr>
              </a:p>
              <a:p>
                <a:endParaRPr lang="en-CA" sz="90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359A998C-98B1-C913-8AD2-BD59B9A55A5C}"/>
                  </a:ext>
                </a:extLst>
              </p:cNvPr>
              <p:cNvSpPr txBox="1"/>
              <p:nvPr/>
            </p:nvSpPr>
            <p:spPr>
              <a:xfrm rot="16200000">
                <a:off x="4382737" y="4900916"/>
                <a:ext cx="168026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900">
                    <a:latin typeface="+mj-lt"/>
                    <a:ea typeface="Calibri" panose="020F0502020204030204" pitchFamily="34" charset="0"/>
                    <a:cs typeface="Calibri" panose="020F0502020204030204" pitchFamily="34" charset="0"/>
                  </a:rPr>
                  <a:t>Log</a:t>
                </a:r>
                <a:r>
                  <a:rPr lang="en-CA" sz="900" baseline="-25000">
                    <a:latin typeface="+mj-lt"/>
                    <a:ea typeface="Calibri" panose="020F0502020204030204" pitchFamily="34" charset="0"/>
                    <a:cs typeface="Calibri" panose="020F0502020204030204" pitchFamily="34" charset="0"/>
                  </a:rPr>
                  <a:t>10</a:t>
                </a:r>
                <a:r>
                  <a:rPr lang="en-CA" sz="900">
                    <a:latin typeface="+mj-lt"/>
                    <a:ea typeface="Calibri" panose="020F0502020204030204" pitchFamily="34" charset="0"/>
                    <a:cs typeface="Calibri" panose="020F0502020204030204" pitchFamily="34" charset="0"/>
                  </a:rPr>
                  <a:t> Mutation Frequency x 10</a:t>
                </a:r>
                <a:r>
                  <a:rPr lang="en-CA" sz="900" baseline="30000">
                    <a:latin typeface="+mj-lt"/>
                    <a:ea typeface="Calibri" panose="020F0502020204030204" pitchFamily="34" charset="0"/>
                    <a:cs typeface="Calibri" panose="020F0502020204030204" pitchFamily="34" charset="0"/>
                  </a:rPr>
                  <a:t>-8 </a:t>
                </a:r>
                <a:endParaRPr lang="en-CA" sz="9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endParaRPr>
              </a:p>
              <a:p>
                <a:endParaRPr lang="en-CA" sz="90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3EC82247-75DD-EF98-9EF3-DBFE6F6DC218}"/>
                </a:ext>
              </a:extLst>
            </p:cNvPr>
            <p:cNvGrpSpPr/>
            <p:nvPr/>
          </p:nvGrpSpPr>
          <p:grpSpPr>
            <a:xfrm>
              <a:off x="2902253" y="1773343"/>
              <a:ext cx="4549595" cy="230832"/>
              <a:chOff x="2902253" y="1773343"/>
              <a:chExt cx="4549595" cy="230832"/>
            </a:xfrm>
          </p:grpSpPr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838826A0-4D88-08FD-C86C-599272E0817F}"/>
                  </a:ext>
                </a:extLst>
              </p:cNvPr>
              <p:cNvSpPr txBox="1"/>
              <p:nvPr/>
            </p:nvSpPr>
            <p:spPr>
              <a:xfrm>
                <a:off x="2902253" y="1773343"/>
                <a:ext cx="1470274" cy="2308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CA" sz="900">
                    <a:latin typeface="+mj-lt"/>
                  </a:rPr>
                  <a:t>Log</a:t>
                </a:r>
                <a:r>
                  <a:rPr lang="en-CA" sz="900" baseline="-25000">
                    <a:latin typeface="+mj-lt"/>
                  </a:rPr>
                  <a:t>10</a:t>
                </a:r>
                <a:r>
                  <a:rPr lang="en-CA" sz="900">
                    <a:latin typeface="+mj-lt"/>
                  </a:rPr>
                  <a:t> Dose (mg/kg BW/day)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727CC6BA-8D38-DCAC-DA10-DFC69662F7E4}"/>
                  </a:ext>
                </a:extLst>
              </p:cNvPr>
              <p:cNvSpPr txBox="1"/>
              <p:nvPr/>
            </p:nvSpPr>
            <p:spPr>
              <a:xfrm>
                <a:off x="5981574" y="1773343"/>
                <a:ext cx="1470274" cy="2308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CA" sz="900">
                    <a:latin typeface="+mj-lt"/>
                  </a:rPr>
                  <a:t>Log</a:t>
                </a:r>
                <a:r>
                  <a:rPr lang="en-CA" sz="900" baseline="-25000">
                    <a:latin typeface="+mj-lt"/>
                  </a:rPr>
                  <a:t>10</a:t>
                </a:r>
                <a:r>
                  <a:rPr lang="en-CA" sz="900">
                    <a:latin typeface="+mj-lt"/>
                  </a:rPr>
                  <a:t> Dose (mg/kg BW/day)</a:t>
                </a:r>
              </a:p>
            </p:txBody>
          </p:sp>
        </p:grp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5CAEFD8C-B46F-4647-7FC6-199E7DF129CE}"/>
                </a:ext>
              </a:extLst>
            </p:cNvPr>
            <p:cNvGrpSpPr/>
            <p:nvPr/>
          </p:nvGrpSpPr>
          <p:grpSpPr>
            <a:xfrm>
              <a:off x="2902253" y="3822372"/>
              <a:ext cx="4549595" cy="230832"/>
              <a:chOff x="2902253" y="3822372"/>
              <a:chExt cx="4549595" cy="230832"/>
            </a:xfrm>
          </p:grpSpPr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F5112AC6-23BD-8F51-DA59-3B9EB7F467C7}"/>
                  </a:ext>
                </a:extLst>
              </p:cNvPr>
              <p:cNvSpPr txBox="1"/>
              <p:nvPr/>
            </p:nvSpPr>
            <p:spPr>
              <a:xfrm>
                <a:off x="2902253" y="3822372"/>
                <a:ext cx="1470274" cy="2308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CA" sz="900">
                    <a:latin typeface="+mj-lt"/>
                  </a:rPr>
                  <a:t>Log</a:t>
                </a:r>
                <a:r>
                  <a:rPr lang="en-CA" sz="900" baseline="-25000">
                    <a:latin typeface="+mj-lt"/>
                  </a:rPr>
                  <a:t>10</a:t>
                </a:r>
                <a:r>
                  <a:rPr lang="en-CA" sz="900">
                    <a:latin typeface="+mj-lt"/>
                  </a:rPr>
                  <a:t> Dose (mg/kg BW/day)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F29A67CF-BE96-EC87-99FD-2C1EF538DC05}"/>
                  </a:ext>
                </a:extLst>
              </p:cNvPr>
              <p:cNvSpPr txBox="1"/>
              <p:nvPr/>
            </p:nvSpPr>
            <p:spPr>
              <a:xfrm>
                <a:off x="5981574" y="3822372"/>
                <a:ext cx="1470274" cy="2308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CA" sz="900">
                    <a:latin typeface="+mj-lt"/>
                  </a:rPr>
                  <a:t>Log</a:t>
                </a:r>
                <a:r>
                  <a:rPr lang="en-CA" sz="900" baseline="-25000">
                    <a:latin typeface="+mj-lt"/>
                  </a:rPr>
                  <a:t>10</a:t>
                </a:r>
                <a:r>
                  <a:rPr lang="en-CA" sz="900">
                    <a:latin typeface="+mj-lt"/>
                  </a:rPr>
                  <a:t> Dose (mg/kg BW/day)</a:t>
                </a:r>
              </a:p>
            </p:txBody>
          </p:sp>
        </p:grp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BAC0133B-4D51-F127-7A3C-AB075474C16D}"/>
                </a:ext>
              </a:extLst>
            </p:cNvPr>
            <p:cNvGrpSpPr/>
            <p:nvPr/>
          </p:nvGrpSpPr>
          <p:grpSpPr>
            <a:xfrm>
              <a:off x="2902253" y="5953269"/>
              <a:ext cx="4549595" cy="230832"/>
              <a:chOff x="2902253" y="5953269"/>
              <a:chExt cx="4549595" cy="230832"/>
            </a:xfrm>
          </p:grpSpPr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369A6E94-0AB7-9D9D-5970-2496F8FB6185}"/>
                  </a:ext>
                </a:extLst>
              </p:cNvPr>
              <p:cNvSpPr txBox="1"/>
              <p:nvPr/>
            </p:nvSpPr>
            <p:spPr>
              <a:xfrm>
                <a:off x="2902253" y="5953269"/>
                <a:ext cx="1470274" cy="2308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CA" sz="900">
                    <a:latin typeface="+mj-lt"/>
                  </a:rPr>
                  <a:t>Log</a:t>
                </a:r>
                <a:r>
                  <a:rPr lang="en-CA" sz="900" baseline="-25000">
                    <a:latin typeface="+mj-lt"/>
                  </a:rPr>
                  <a:t>10</a:t>
                </a:r>
                <a:r>
                  <a:rPr lang="en-CA" sz="900">
                    <a:latin typeface="+mj-lt"/>
                  </a:rPr>
                  <a:t> Dose (mg/kg BW/day)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C5B1E8F5-DFF0-7D89-E3A6-C5A93AE0F039}"/>
                  </a:ext>
                </a:extLst>
              </p:cNvPr>
              <p:cNvSpPr txBox="1"/>
              <p:nvPr/>
            </p:nvSpPr>
            <p:spPr>
              <a:xfrm>
                <a:off x="5981574" y="5953269"/>
                <a:ext cx="1470274" cy="2308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CA" sz="900">
                    <a:latin typeface="+mj-lt"/>
                  </a:rPr>
                  <a:t>Log</a:t>
                </a:r>
                <a:r>
                  <a:rPr lang="en-CA" sz="900" baseline="-25000">
                    <a:latin typeface="+mj-lt"/>
                  </a:rPr>
                  <a:t>10</a:t>
                </a:r>
                <a:r>
                  <a:rPr lang="en-CA" sz="900">
                    <a:latin typeface="+mj-lt"/>
                  </a:rPr>
                  <a:t> Dose (mg/kg BW/day)</a:t>
                </a:r>
              </a:p>
            </p:txBody>
          </p:sp>
        </p:grp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34822096-407C-9298-2008-0D35BB85BD42}"/>
              </a:ext>
            </a:extLst>
          </p:cNvPr>
          <p:cNvSpPr txBox="1"/>
          <p:nvPr/>
        </p:nvSpPr>
        <p:spPr>
          <a:xfrm>
            <a:off x="8629650" y="2442635"/>
            <a:ext cx="3200400" cy="12103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n-CA" sz="1600" b="1" kern="10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</a:t>
            </a:r>
            <a:r>
              <a:rPr lang="en-CA" sz="1600" kern="10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CA" sz="1600" b="1" kern="10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gure</a:t>
            </a:r>
            <a:r>
              <a:rPr lang="en-CA" sz="1600" kern="10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CA" sz="1600" b="1" kern="10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2.</a:t>
            </a:r>
            <a:r>
              <a:rPr lang="en-CA" sz="1600" kern="10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PROAST output of the individual dose-response relationships for the 6 Hawk-Seq™ datasets.</a:t>
            </a:r>
            <a:endParaRPr lang="en-CA" sz="2400" kern="10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807388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oup 23">
            <a:extLst>
              <a:ext uri="{FF2B5EF4-FFF2-40B4-BE49-F238E27FC236}">
                <a16:creationId xmlns:a16="http://schemas.microsoft.com/office/drawing/2014/main" id="{B46B0BD7-8FC6-C98E-E85D-D4D610F0951D}"/>
              </a:ext>
            </a:extLst>
          </p:cNvPr>
          <p:cNvGrpSpPr>
            <a:grpSpLocks/>
          </p:cNvGrpSpPr>
          <p:nvPr/>
        </p:nvGrpSpPr>
        <p:grpSpPr>
          <a:xfrm>
            <a:off x="990598" y="17300"/>
            <a:ext cx="6032368" cy="6206806"/>
            <a:chOff x="352423" y="0"/>
            <a:chExt cx="6032368" cy="6206806"/>
          </a:xfrm>
        </p:grpSpPr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BEB70EAE-0749-B542-CF41-B2A41A60FA3F}"/>
                </a:ext>
              </a:extLst>
            </p:cNvPr>
            <p:cNvGrpSpPr>
              <a:grpSpLocks/>
            </p:cNvGrpSpPr>
            <p:nvPr/>
          </p:nvGrpSpPr>
          <p:grpSpPr>
            <a:xfrm>
              <a:off x="352424" y="0"/>
              <a:ext cx="6032367" cy="3025289"/>
              <a:chOff x="352424" y="0"/>
              <a:chExt cx="6032367" cy="3025289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F0A0BC9D-FF01-6252-2719-1C8DDE8CD02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9744"/>
              <a:stretch>
                <a:fillRect/>
              </a:stretch>
            </p:blipFill>
            <p:spPr bwMode="auto">
              <a:xfrm>
                <a:off x="352424" y="0"/>
                <a:ext cx="6032367" cy="3025289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8EEF1C72-1A27-BEC6-070D-83DC44FF7C4E}"/>
                  </a:ext>
                </a:extLst>
              </p:cNvPr>
              <p:cNvSpPr txBox="1">
                <a:spLocks/>
              </p:cNvSpPr>
              <p:nvPr/>
            </p:nvSpPr>
            <p:spPr>
              <a:xfrm rot="16200000">
                <a:off x="-434564" y="1122193"/>
                <a:ext cx="208031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000">
                    <a:latin typeface="+mj-lt"/>
                    <a:ea typeface="Calibri" panose="020F0502020204030204" pitchFamily="34" charset="0"/>
                    <a:cs typeface="Calibri" panose="020F0502020204030204" pitchFamily="34" charset="0"/>
                  </a:rPr>
                  <a:t>Log</a:t>
                </a:r>
                <a:r>
                  <a:rPr lang="en-CA" sz="1000" baseline="-25000">
                    <a:latin typeface="+mj-lt"/>
                    <a:ea typeface="Calibri" panose="020F0502020204030204" pitchFamily="34" charset="0"/>
                    <a:cs typeface="Calibri" panose="020F0502020204030204" pitchFamily="34" charset="0"/>
                  </a:rPr>
                  <a:t>10</a:t>
                </a:r>
                <a:r>
                  <a:rPr lang="en-CA" sz="1000">
                    <a:latin typeface="+mj-lt"/>
                    <a:ea typeface="Calibri" panose="020F0502020204030204" pitchFamily="34" charset="0"/>
                    <a:cs typeface="Calibri" panose="020F0502020204030204" pitchFamily="34" charset="0"/>
                  </a:rPr>
                  <a:t> Mutation Frequency x 10</a:t>
                </a:r>
                <a:r>
                  <a:rPr lang="en-CA" sz="1000" baseline="30000">
                    <a:latin typeface="+mj-lt"/>
                    <a:ea typeface="Calibri" panose="020F0502020204030204" pitchFamily="34" charset="0"/>
                    <a:cs typeface="Calibri" panose="020F0502020204030204" pitchFamily="34" charset="0"/>
                  </a:rPr>
                  <a:t>-8 </a:t>
                </a:r>
                <a:endParaRPr lang="en-CA" sz="1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endParaRPr>
              </a:p>
              <a:p>
                <a:endParaRPr lang="en-CA" sz="80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2BE9506C-DEC8-A42F-8A2F-C1943996CDA0}"/>
                  </a:ext>
                </a:extLst>
              </p:cNvPr>
              <p:cNvSpPr txBox="1">
                <a:spLocks/>
              </p:cNvSpPr>
              <p:nvPr/>
            </p:nvSpPr>
            <p:spPr>
              <a:xfrm rot="16200000">
                <a:off x="2622961" y="1026943"/>
                <a:ext cx="208031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000">
                    <a:latin typeface="+mj-lt"/>
                    <a:ea typeface="Calibri" panose="020F0502020204030204" pitchFamily="34" charset="0"/>
                    <a:cs typeface="Calibri" panose="020F0502020204030204" pitchFamily="34" charset="0"/>
                  </a:rPr>
                  <a:t>Log</a:t>
                </a:r>
                <a:r>
                  <a:rPr lang="en-CA" sz="1000" baseline="-25000">
                    <a:latin typeface="+mj-lt"/>
                    <a:ea typeface="Calibri" panose="020F0502020204030204" pitchFamily="34" charset="0"/>
                    <a:cs typeface="Calibri" panose="020F0502020204030204" pitchFamily="34" charset="0"/>
                  </a:rPr>
                  <a:t>10</a:t>
                </a:r>
                <a:r>
                  <a:rPr lang="en-CA" sz="1000">
                    <a:latin typeface="+mj-lt"/>
                    <a:ea typeface="Calibri" panose="020F0502020204030204" pitchFamily="34" charset="0"/>
                    <a:cs typeface="Calibri" panose="020F0502020204030204" pitchFamily="34" charset="0"/>
                  </a:rPr>
                  <a:t> Mutation Frequency x 10</a:t>
                </a:r>
                <a:r>
                  <a:rPr lang="en-CA" sz="1000" baseline="30000">
                    <a:latin typeface="+mj-lt"/>
                    <a:ea typeface="Calibri" panose="020F0502020204030204" pitchFamily="34" charset="0"/>
                    <a:cs typeface="Calibri" panose="020F0502020204030204" pitchFamily="34" charset="0"/>
                  </a:rPr>
                  <a:t>-8 </a:t>
                </a:r>
                <a:endParaRPr lang="en-CA" sz="1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endParaRPr>
              </a:p>
              <a:p>
                <a:endParaRPr lang="en-CA" sz="80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A3538034-AF4D-CDB1-DCA6-DE88377190BE}"/>
                  </a:ext>
                </a:extLst>
              </p:cNvPr>
              <p:cNvGrpSpPr>
                <a:grpSpLocks/>
              </p:cNvGrpSpPr>
              <p:nvPr/>
            </p:nvGrpSpPr>
            <p:grpSpPr>
              <a:xfrm>
                <a:off x="1340153" y="2779068"/>
                <a:ext cx="4597139" cy="246221"/>
                <a:chOff x="1340153" y="2779068"/>
                <a:chExt cx="4597139" cy="246221"/>
              </a:xfrm>
            </p:grpSpPr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4F2A5C28-D39C-C8CE-413C-73749096F59D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1340153" y="2779068"/>
                  <a:ext cx="1612942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CA" sz="1000">
                      <a:latin typeface="+mj-lt"/>
                    </a:rPr>
                    <a:t>Log</a:t>
                  </a:r>
                  <a:r>
                    <a:rPr lang="en-CA" sz="1000" baseline="-25000">
                      <a:latin typeface="+mj-lt"/>
                    </a:rPr>
                    <a:t>10</a:t>
                  </a:r>
                  <a:r>
                    <a:rPr lang="en-CA" sz="1000">
                      <a:latin typeface="+mj-lt"/>
                    </a:rPr>
                    <a:t> Dose (mg/kg BW/day)</a:t>
                  </a:r>
                </a:p>
              </p:txBody>
            </p: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53C34B59-B2E3-D2E6-2C68-C3AC25DEF04A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4324350" y="2779068"/>
                  <a:ext cx="1612942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CA" sz="1000">
                      <a:latin typeface="+mj-lt"/>
                    </a:rPr>
                    <a:t>Log</a:t>
                  </a:r>
                  <a:r>
                    <a:rPr lang="en-CA" sz="1000" baseline="-25000">
                      <a:latin typeface="+mj-lt"/>
                    </a:rPr>
                    <a:t>10</a:t>
                  </a:r>
                  <a:r>
                    <a:rPr lang="en-CA" sz="1000">
                      <a:latin typeface="+mj-lt"/>
                    </a:rPr>
                    <a:t> Dose (mg/kg BW/day)</a:t>
                  </a:r>
                </a:p>
              </p:txBody>
            </p:sp>
          </p:grp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863098C1-F924-FE97-E1B0-907914B68532}"/>
                </a:ext>
              </a:extLst>
            </p:cNvPr>
            <p:cNvGrpSpPr>
              <a:grpSpLocks/>
            </p:cNvGrpSpPr>
            <p:nvPr/>
          </p:nvGrpSpPr>
          <p:grpSpPr>
            <a:xfrm>
              <a:off x="352423" y="3196739"/>
              <a:ext cx="6032367" cy="3010067"/>
              <a:chOff x="2124074" y="3025122"/>
              <a:chExt cx="6032367" cy="3010067"/>
            </a:xfrm>
          </p:grpSpPr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FCED1E6F-2D6C-FB45-AA8B-51C8B9FF335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0253"/>
              <a:stretch>
                <a:fillRect/>
              </a:stretch>
            </p:blipFill>
            <p:spPr bwMode="auto">
              <a:xfrm>
                <a:off x="2124074" y="3025122"/>
                <a:ext cx="6032367" cy="2994677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DDBAF32F-9844-F853-4CDA-9F07E21701F5}"/>
                  </a:ext>
                </a:extLst>
              </p:cNvPr>
              <p:cNvSpPr txBox="1">
                <a:spLocks/>
              </p:cNvSpPr>
              <p:nvPr/>
            </p:nvSpPr>
            <p:spPr>
              <a:xfrm rot="16200000">
                <a:off x="1428416" y="4193164"/>
                <a:ext cx="189766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000">
                    <a:latin typeface="+mj-lt"/>
                    <a:ea typeface="Calibri" panose="020F0502020204030204" pitchFamily="34" charset="0"/>
                    <a:cs typeface="Calibri" panose="020F0502020204030204" pitchFamily="34" charset="0"/>
                  </a:rPr>
                  <a:t>Log</a:t>
                </a:r>
                <a:r>
                  <a:rPr lang="en-CA" sz="1000" baseline="-25000">
                    <a:latin typeface="+mj-lt"/>
                    <a:ea typeface="Calibri" panose="020F0502020204030204" pitchFamily="34" charset="0"/>
                    <a:cs typeface="Calibri" panose="020F0502020204030204" pitchFamily="34" charset="0"/>
                  </a:rPr>
                  <a:t>10</a:t>
                </a:r>
                <a:r>
                  <a:rPr lang="en-CA" sz="1000">
                    <a:latin typeface="+mj-lt"/>
                    <a:ea typeface="Calibri" panose="020F0502020204030204" pitchFamily="34" charset="0"/>
                    <a:cs typeface="Calibri" panose="020F0502020204030204" pitchFamily="34" charset="0"/>
                  </a:rPr>
                  <a:t> Mutation Frequency x 10</a:t>
                </a:r>
                <a:r>
                  <a:rPr lang="en-CA" sz="1000" baseline="30000">
                    <a:latin typeface="+mj-lt"/>
                    <a:ea typeface="Calibri" panose="020F0502020204030204" pitchFamily="34" charset="0"/>
                    <a:cs typeface="Calibri" panose="020F0502020204030204" pitchFamily="34" charset="0"/>
                  </a:rPr>
                  <a:t>-8 </a:t>
                </a:r>
                <a:endParaRPr lang="en-CA" sz="1000">
                  <a:latin typeface="+mj-lt"/>
                  <a:ea typeface="Calibri" panose="020F0502020204030204" pitchFamily="34" charset="0"/>
                  <a:cs typeface="Calibri" panose="020F0502020204030204" pitchFamily="34" charset="0"/>
                </a:endParaRPr>
              </a:p>
              <a:p>
                <a:endParaRPr lang="en-CA" sz="80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691DD164-7572-4D12-40C9-D6BC8E727010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3111803" y="5788968"/>
                <a:ext cx="1612942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CA" sz="1000">
                    <a:latin typeface="+mj-lt"/>
                  </a:rPr>
                  <a:t>Log</a:t>
                </a:r>
                <a:r>
                  <a:rPr lang="en-CA" sz="1000" baseline="-25000">
                    <a:latin typeface="+mj-lt"/>
                  </a:rPr>
                  <a:t>10</a:t>
                </a:r>
                <a:r>
                  <a:rPr lang="en-CA" sz="1000">
                    <a:latin typeface="+mj-lt"/>
                  </a:rPr>
                  <a:t> Dose (mg/kg BW/day)</a:t>
                </a:r>
              </a:p>
            </p:txBody>
          </p:sp>
        </p:grp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7BDB03BB-C399-14C3-897B-66B29C57198F}"/>
              </a:ext>
            </a:extLst>
          </p:cNvPr>
          <p:cNvSpPr txBox="1"/>
          <p:nvPr/>
        </p:nvSpPr>
        <p:spPr>
          <a:xfrm>
            <a:off x="5768996" y="4036320"/>
            <a:ext cx="3324225" cy="13501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n-CA" sz="1800" b="1" kern="10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</a:t>
            </a:r>
            <a:r>
              <a:rPr lang="en-CA" sz="1800" kern="10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CA" sz="1800" b="1" kern="10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gure</a:t>
            </a:r>
            <a:r>
              <a:rPr lang="en-CA" sz="1800" kern="10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CA" sz="1800" b="1" kern="10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3.</a:t>
            </a:r>
            <a:r>
              <a:rPr lang="en-CA" sz="1800" kern="10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PROAST output of the individual dose-response relationships for the 3 PECC-Seq datasets.</a:t>
            </a:r>
            <a:endParaRPr lang="en-CA" sz="2800" kern="10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41669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6</TotalTime>
  <Words>892</Words>
  <Application>Microsoft Office PowerPoint</Application>
  <PresentationFormat>Widescreen</PresentationFormat>
  <Paragraphs>11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ptos</vt:lpstr>
      <vt:lpstr>Aptos Display</vt:lpstr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ron Mulugeta</dc:creator>
  <cp:lastModifiedBy>White, Paul (HC/SC)</cp:lastModifiedBy>
  <cp:revision>6</cp:revision>
  <dcterms:created xsi:type="dcterms:W3CDTF">2025-10-22T19:52:37Z</dcterms:created>
  <dcterms:modified xsi:type="dcterms:W3CDTF">2026-02-13T19:28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05d8ed60-cd71-485b-a85b-277aaf32f506_Enabled">
    <vt:lpwstr>true</vt:lpwstr>
  </property>
  <property fmtid="{D5CDD505-2E9C-101B-9397-08002B2CF9AE}" pid="3" name="MSIP_Label_05d8ed60-cd71-485b-a85b-277aaf32f506_SetDate">
    <vt:lpwstr>2025-10-23T08:30:31Z</vt:lpwstr>
  </property>
  <property fmtid="{D5CDD505-2E9C-101B-9397-08002B2CF9AE}" pid="4" name="MSIP_Label_05d8ed60-cd71-485b-a85b-277aaf32f506_Method">
    <vt:lpwstr>Standard</vt:lpwstr>
  </property>
  <property fmtid="{D5CDD505-2E9C-101B-9397-08002B2CF9AE}" pid="5" name="MSIP_Label_05d8ed60-cd71-485b-a85b-277aaf32f506_Name">
    <vt:lpwstr>Unclassified</vt:lpwstr>
  </property>
  <property fmtid="{D5CDD505-2E9C-101B-9397-08002B2CF9AE}" pid="6" name="MSIP_Label_05d8ed60-cd71-485b-a85b-277aaf32f506_SiteId">
    <vt:lpwstr>42fd9015-de4d-4223-a368-baeacab48927</vt:lpwstr>
  </property>
  <property fmtid="{D5CDD505-2E9C-101B-9397-08002B2CF9AE}" pid="7" name="MSIP_Label_05d8ed60-cd71-485b-a85b-277aaf32f506_ActionId">
    <vt:lpwstr>f312eb1b-9cf4-4a26-9507-94e8bebea4cb</vt:lpwstr>
  </property>
  <property fmtid="{D5CDD505-2E9C-101B-9397-08002B2CF9AE}" pid="8" name="MSIP_Label_05d8ed60-cd71-485b-a85b-277aaf32f506_ContentBits">
    <vt:lpwstr>1</vt:lpwstr>
  </property>
  <property fmtid="{D5CDD505-2E9C-101B-9397-08002B2CF9AE}" pid="9" name="MSIP_Label_05d8ed60-cd71-485b-a85b-277aaf32f506_Tag">
    <vt:lpwstr>10, 3, 0, 1</vt:lpwstr>
  </property>
  <property fmtid="{D5CDD505-2E9C-101B-9397-08002B2CF9AE}" pid="10" name="ClassificationContentMarkingHeaderLocations">
    <vt:lpwstr>Office Theme:8</vt:lpwstr>
  </property>
  <property fmtid="{D5CDD505-2E9C-101B-9397-08002B2CF9AE}" pid="11" name="ClassificationContentMarkingHeaderText">
    <vt:lpwstr>Unclassified / Non classifié</vt:lpwstr>
  </property>
</Properties>
</file>